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3" r:id="rId8"/>
    <p:sldId id="264" r:id="rId9"/>
    <p:sldId id="265" r:id="rId10"/>
    <p:sldId id="266" r:id="rId11"/>
    <p:sldId id="268" r:id="rId12"/>
    <p:sldId id="269" r:id="rId13"/>
    <p:sldId id="270" r:id="rId14"/>
    <p:sldId id="271" r:id="rId15"/>
    <p:sldId id="272" r:id="rId16"/>
    <p:sldId id="274" r:id="rId17"/>
    <p:sldId id="275" r:id="rId18"/>
    <p:sldId id="276" r:id="rId19"/>
    <p:sldId id="277" r:id="rId20"/>
    <p:sldId id="278" r:id="rId21"/>
    <p:sldId id="279" r:id="rId22"/>
    <p:sldId id="281" r:id="rId23"/>
    <p:sldId id="282" r:id="rId24"/>
    <p:sldId id="283" r:id="rId25"/>
    <p:sldId id="287" r:id="rId26"/>
    <p:sldId id="288" r:id="rId27"/>
    <p:sldId id="290" r:id="rId28"/>
    <p:sldId id="291" r:id="rId29"/>
    <p:sldId id="292" r:id="rId30"/>
    <p:sldId id="293" r:id="rId31"/>
    <p:sldId id="294" r:id="rId3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127" d="100"/>
          <a:sy n="127" d="100"/>
        </p:scale>
        <p:origin x="106" y="9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1843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8412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0879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3960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1659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95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22195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3869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4047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2011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0277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2525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712CA3-7E3E-41B1-8E26-E5BEA2CCF514}" type="datetimeFigureOut">
              <a:rPr lang="ko-KR" altLang="en-US" smtClean="0"/>
              <a:t>2018-05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3D1A6D-33AB-407D-B55A-18CBB61B14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8762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8" Type="http://schemas.microsoft.com/office/2007/relationships/hdphoto" Target="../media/hdphoto31.wdp"/><Relationship Id="rId13" Type="http://schemas.openxmlformats.org/officeDocument/2006/relationships/image" Target="../media/image105.jpeg"/><Relationship Id="rId3" Type="http://schemas.openxmlformats.org/officeDocument/2006/relationships/image" Target="../media/image98.jpeg"/><Relationship Id="rId7" Type="http://schemas.openxmlformats.org/officeDocument/2006/relationships/image" Target="../media/image101.jpeg"/><Relationship Id="rId12" Type="http://schemas.microsoft.com/office/2007/relationships/hdphoto" Target="../media/hdphoto32.wdp"/><Relationship Id="rId17" Type="http://schemas.openxmlformats.org/officeDocument/2006/relationships/image" Target="../media/image108.jpeg"/><Relationship Id="rId2" Type="http://schemas.openxmlformats.org/officeDocument/2006/relationships/image" Target="../media/image97.jpeg"/><Relationship Id="rId16" Type="http://schemas.microsoft.com/office/2007/relationships/hdphoto" Target="../media/hdphoto33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0.jpeg"/><Relationship Id="rId11" Type="http://schemas.openxmlformats.org/officeDocument/2006/relationships/image" Target="../media/image104.jpeg"/><Relationship Id="rId5" Type="http://schemas.openxmlformats.org/officeDocument/2006/relationships/image" Target="../media/image99.jpeg"/><Relationship Id="rId15" Type="http://schemas.openxmlformats.org/officeDocument/2006/relationships/image" Target="../media/image107.jpeg"/><Relationship Id="rId10" Type="http://schemas.openxmlformats.org/officeDocument/2006/relationships/image" Target="../media/image103.jpeg"/><Relationship Id="rId4" Type="http://schemas.microsoft.com/office/2007/relationships/hdphoto" Target="../media/hdphoto30.wdp"/><Relationship Id="rId9" Type="http://schemas.openxmlformats.org/officeDocument/2006/relationships/image" Target="../media/image102.jpeg"/><Relationship Id="rId14" Type="http://schemas.openxmlformats.org/officeDocument/2006/relationships/image" Target="../media/image106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jpeg"/><Relationship Id="rId7" Type="http://schemas.openxmlformats.org/officeDocument/2006/relationships/image" Target="../media/image114.jpeg"/><Relationship Id="rId2" Type="http://schemas.openxmlformats.org/officeDocument/2006/relationships/image" Target="../media/image10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3.jpeg"/><Relationship Id="rId5" Type="http://schemas.openxmlformats.org/officeDocument/2006/relationships/image" Target="../media/image112.jpeg"/><Relationship Id="rId4" Type="http://schemas.openxmlformats.org/officeDocument/2006/relationships/image" Target="../media/image111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1.jpeg"/><Relationship Id="rId13" Type="http://schemas.openxmlformats.org/officeDocument/2006/relationships/image" Target="../media/image125.jpeg"/><Relationship Id="rId3" Type="http://schemas.openxmlformats.org/officeDocument/2006/relationships/image" Target="../media/image116.jpeg"/><Relationship Id="rId7" Type="http://schemas.openxmlformats.org/officeDocument/2006/relationships/image" Target="../media/image120.jpeg"/><Relationship Id="rId12" Type="http://schemas.microsoft.com/office/2007/relationships/hdphoto" Target="../media/hdphoto34.wdp"/><Relationship Id="rId2" Type="http://schemas.openxmlformats.org/officeDocument/2006/relationships/image" Target="../media/image1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9.jpeg"/><Relationship Id="rId11" Type="http://schemas.openxmlformats.org/officeDocument/2006/relationships/image" Target="../media/image124.jpeg"/><Relationship Id="rId5" Type="http://schemas.openxmlformats.org/officeDocument/2006/relationships/image" Target="../media/image118.jpeg"/><Relationship Id="rId10" Type="http://schemas.openxmlformats.org/officeDocument/2006/relationships/image" Target="../media/image123.jpeg"/><Relationship Id="rId4" Type="http://schemas.openxmlformats.org/officeDocument/2006/relationships/image" Target="../media/image117.jpeg"/><Relationship Id="rId9" Type="http://schemas.openxmlformats.org/officeDocument/2006/relationships/image" Target="../media/image122.jpeg"/><Relationship Id="rId14" Type="http://schemas.openxmlformats.org/officeDocument/2006/relationships/image" Target="../media/image126.jpe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3.jpeg"/><Relationship Id="rId13" Type="http://schemas.openxmlformats.org/officeDocument/2006/relationships/image" Target="../media/image137.jpeg"/><Relationship Id="rId3" Type="http://schemas.openxmlformats.org/officeDocument/2006/relationships/image" Target="../media/image128.jpeg"/><Relationship Id="rId7" Type="http://schemas.openxmlformats.org/officeDocument/2006/relationships/image" Target="../media/image132.jpeg"/><Relationship Id="rId12" Type="http://schemas.openxmlformats.org/officeDocument/2006/relationships/image" Target="../media/image136.jpeg"/><Relationship Id="rId2" Type="http://schemas.openxmlformats.org/officeDocument/2006/relationships/image" Target="../media/image12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1.jpeg"/><Relationship Id="rId11" Type="http://schemas.openxmlformats.org/officeDocument/2006/relationships/image" Target="../media/image135.jpeg"/><Relationship Id="rId5" Type="http://schemas.openxmlformats.org/officeDocument/2006/relationships/image" Target="../media/image130.jpeg"/><Relationship Id="rId10" Type="http://schemas.openxmlformats.org/officeDocument/2006/relationships/image" Target="../media/image134.jpeg"/><Relationship Id="rId4" Type="http://schemas.openxmlformats.org/officeDocument/2006/relationships/image" Target="../media/image129.jpeg"/><Relationship Id="rId9" Type="http://schemas.microsoft.com/office/2007/relationships/hdphoto" Target="../media/hdphoto35.wdp"/><Relationship Id="rId14" Type="http://schemas.openxmlformats.org/officeDocument/2006/relationships/image" Target="../media/image138.jpe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4.jpeg"/><Relationship Id="rId13" Type="http://schemas.openxmlformats.org/officeDocument/2006/relationships/image" Target="../media/image148.jpeg"/><Relationship Id="rId3" Type="http://schemas.openxmlformats.org/officeDocument/2006/relationships/image" Target="../media/image140.jpeg"/><Relationship Id="rId7" Type="http://schemas.openxmlformats.org/officeDocument/2006/relationships/image" Target="../media/image143.jpeg"/><Relationship Id="rId12" Type="http://schemas.openxmlformats.org/officeDocument/2006/relationships/image" Target="../media/image147.jpeg"/><Relationship Id="rId2" Type="http://schemas.openxmlformats.org/officeDocument/2006/relationships/image" Target="../media/image139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36.wdp"/><Relationship Id="rId11" Type="http://schemas.openxmlformats.org/officeDocument/2006/relationships/image" Target="../media/image146.jpeg"/><Relationship Id="rId5" Type="http://schemas.openxmlformats.org/officeDocument/2006/relationships/image" Target="../media/image142.jpeg"/><Relationship Id="rId15" Type="http://schemas.openxmlformats.org/officeDocument/2006/relationships/image" Target="../media/image150.jpeg"/><Relationship Id="rId10" Type="http://schemas.openxmlformats.org/officeDocument/2006/relationships/image" Target="../media/image145.jpeg"/><Relationship Id="rId4" Type="http://schemas.openxmlformats.org/officeDocument/2006/relationships/image" Target="../media/image141.jpeg"/><Relationship Id="rId9" Type="http://schemas.microsoft.com/office/2007/relationships/hdphoto" Target="../media/hdphoto37.wdp"/><Relationship Id="rId14" Type="http://schemas.openxmlformats.org/officeDocument/2006/relationships/image" Target="../media/image149.jpeg"/></Relationships>
</file>

<file path=ppt/slides/_rels/slide15.xml.rels><?xml version="1.0" encoding="UTF-8" standalone="yes"?>
<Relationships xmlns="http://schemas.openxmlformats.org/package/2006/relationships"><Relationship Id="rId8" Type="http://schemas.microsoft.com/office/2007/relationships/hdphoto" Target="../media/hdphoto40.wdp"/><Relationship Id="rId13" Type="http://schemas.microsoft.com/office/2007/relationships/hdphoto" Target="../media/hdphoto42.wdp"/><Relationship Id="rId18" Type="http://schemas.microsoft.com/office/2007/relationships/hdphoto" Target="../media/hdphoto44.wdp"/><Relationship Id="rId3" Type="http://schemas.microsoft.com/office/2007/relationships/hdphoto" Target="../media/hdphoto38.wdp"/><Relationship Id="rId21" Type="http://schemas.openxmlformats.org/officeDocument/2006/relationships/image" Target="../media/image162.jpeg"/><Relationship Id="rId7" Type="http://schemas.openxmlformats.org/officeDocument/2006/relationships/image" Target="../media/image154.jpeg"/><Relationship Id="rId12" Type="http://schemas.openxmlformats.org/officeDocument/2006/relationships/image" Target="../media/image157.jpeg"/><Relationship Id="rId17" Type="http://schemas.openxmlformats.org/officeDocument/2006/relationships/image" Target="../media/image160.jpeg"/><Relationship Id="rId2" Type="http://schemas.openxmlformats.org/officeDocument/2006/relationships/image" Target="../media/image151.jpeg"/><Relationship Id="rId16" Type="http://schemas.openxmlformats.org/officeDocument/2006/relationships/image" Target="../media/image159.jpeg"/><Relationship Id="rId20" Type="http://schemas.microsoft.com/office/2007/relationships/hdphoto" Target="../media/hdphoto45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3.jpeg"/><Relationship Id="rId11" Type="http://schemas.openxmlformats.org/officeDocument/2006/relationships/image" Target="../media/image156.jpeg"/><Relationship Id="rId5" Type="http://schemas.microsoft.com/office/2007/relationships/hdphoto" Target="../media/hdphoto39.wdp"/><Relationship Id="rId15" Type="http://schemas.microsoft.com/office/2007/relationships/hdphoto" Target="../media/hdphoto43.wdp"/><Relationship Id="rId10" Type="http://schemas.microsoft.com/office/2007/relationships/hdphoto" Target="../media/hdphoto41.wdp"/><Relationship Id="rId19" Type="http://schemas.openxmlformats.org/officeDocument/2006/relationships/image" Target="../media/image161.jpeg"/><Relationship Id="rId4" Type="http://schemas.openxmlformats.org/officeDocument/2006/relationships/image" Target="../media/image152.jpeg"/><Relationship Id="rId9" Type="http://schemas.openxmlformats.org/officeDocument/2006/relationships/image" Target="../media/image155.jpeg"/><Relationship Id="rId14" Type="http://schemas.openxmlformats.org/officeDocument/2006/relationships/image" Target="../media/image158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7.jpeg"/><Relationship Id="rId3" Type="http://schemas.microsoft.com/office/2007/relationships/hdphoto" Target="../media/hdphoto46.wdp"/><Relationship Id="rId7" Type="http://schemas.openxmlformats.org/officeDocument/2006/relationships/image" Target="../media/image166.jpeg"/><Relationship Id="rId2" Type="http://schemas.openxmlformats.org/officeDocument/2006/relationships/image" Target="../media/image16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5.jpeg"/><Relationship Id="rId5" Type="http://schemas.microsoft.com/office/2007/relationships/hdphoto" Target="../media/hdphoto47.wdp"/><Relationship Id="rId4" Type="http://schemas.openxmlformats.org/officeDocument/2006/relationships/image" Target="../media/image164.jpeg"/><Relationship Id="rId9" Type="http://schemas.openxmlformats.org/officeDocument/2006/relationships/image" Target="../media/image168.jpe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5.jpeg"/><Relationship Id="rId13" Type="http://schemas.openxmlformats.org/officeDocument/2006/relationships/image" Target="../media/image180.jpeg"/><Relationship Id="rId3" Type="http://schemas.openxmlformats.org/officeDocument/2006/relationships/image" Target="../media/image170.jpeg"/><Relationship Id="rId7" Type="http://schemas.openxmlformats.org/officeDocument/2006/relationships/image" Target="../media/image174.jpeg"/><Relationship Id="rId12" Type="http://schemas.openxmlformats.org/officeDocument/2006/relationships/image" Target="../media/image179.jpeg"/><Relationship Id="rId2" Type="http://schemas.openxmlformats.org/officeDocument/2006/relationships/image" Target="../media/image169.jpeg"/><Relationship Id="rId16" Type="http://schemas.openxmlformats.org/officeDocument/2006/relationships/image" Target="../media/image18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3.jpeg"/><Relationship Id="rId11" Type="http://schemas.openxmlformats.org/officeDocument/2006/relationships/image" Target="../media/image178.jpeg"/><Relationship Id="rId5" Type="http://schemas.openxmlformats.org/officeDocument/2006/relationships/image" Target="../media/image172.jpeg"/><Relationship Id="rId15" Type="http://schemas.openxmlformats.org/officeDocument/2006/relationships/image" Target="../media/image182.jpeg"/><Relationship Id="rId10" Type="http://schemas.openxmlformats.org/officeDocument/2006/relationships/image" Target="../media/image177.jpeg"/><Relationship Id="rId4" Type="http://schemas.openxmlformats.org/officeDocument/2006/relationships/image" Target="../media/image171.jpeg"/><Relationship Id="rId9" Type="http://schemas.openxmlformats.org/officeDocument/2006/relationships/image" Target="../media/image176.jpeg"/><Relationship Id="rId14" Type="http://schemas.openxmlformats.org/officeDocument/2006/relationships/image" Target="../media/image181.jpe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9.jpeg"/><Relationship Id="rId13" Type="http://schemas.openxmlformats.org/officeDocument/2006/relationships/image" Target="../media/image193.jpeg"/><Relationship Id="rId3" Type="http://schemas.openxmlformats.org/officeDocument/2006/relationships/image" Target="../media/image185.jpeg"/><Relationship Id="rId7" Type="http://schemas.microsoft.com/office/2007/relationships/hdphoto" Target="../media/hdphoto48.wdp"/><Relationship Id="rId12" Type="http://schemas.openxmlformats.org/officeDocument/2006/relationships/image" Target="../media/image192.jpeg"/><Relationship Id="rId2" Type="http://schemas.openxmlformats.org/officeDocument/2006/relationships/image" Target="../media/image18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8.jpeg"/><Relationship Id="rId11" Type="http://schemas.openxmlformats.org/officeDocument/2006/relationships/image" Target="../media/image191.jpeg"/><Relationship Id="rId5" Type="http://schemas.openxmlformats.org/officeDocument/2006/relationships/image" Target="../media/image187.jpeg"/><Relationship Id="rId15" Type="http://schemas.openxmlformats.org/officeDocument/2006/relationships/image" Target="../media/image195.jpeg"/><Relationship Id="rId10" Type="http://schemas.microsoft.com/office/2007/relationships/hdphoto" Target="../media/hdphoto49.wdp"/><Relationship Id="rId4" Type="http://schemas.openxmlformats.org/officeDocument/2006/relationships/image" Target="../media/image186.jpeg"/><Relationship Id="rId9" Type="http://schemas.openxmlformats.org/officeDocument/2006/relationships/image" Target="../media/image190.jpeg"/><Relationship Id="rId14" Type="http://schemas.openxmlformats.org/officeDocument/2006/relationships/image" Target="../media/image194.jpe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1.jpeg"/><Relationship Id="rId13" Type="http://schemas.openxmlformats.org/officeDocument/2006/relationships/image" Target="../media/image206.jpeg"/><Relationship Id="rId3" Type="http://schemas.microsoft.com/office/2007/relationships/hdphoto" Target="../media/hdphoto50.wdp"/><Relationship Id="rId7" Type="http://schemas.openxmlformats.org/officeDocument/2006/relationships/image" Target="../media/image200.jpeg"/><Relationship Id="rId12" Type="http://schemas.openxmlformats.org/officeDocument/2006/relationships/image" Target="../media/image205.jpeg"/><Relationship Id="rId2" Type="http://schemas.openxmlformats.org/officeDocument/2006/relationships/image" Target="../media/image19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9.jpeg"/><Relationship Id="rId11" Type="http://schemas.openxmlformats.org/officeDocument/2006/relationships/image" Target="../media/image204.jpeg"/><Relationship Id="rId5" Type="http://schemas.openxmlformats.org/officeDocument/2006/relationships/image" Target="../media/image198.jpeg"/><Relationship Id="rId10" Type="http://schemas.openxmlformats.org/officeDocument/2006/relationships/image" Target="../media/image203.jpeg"/><Relationship Id="rId4" Type="http://schemas.openxmlformats.org/officeDocument/2006/relationships/image" Target="../media/image197.jpeg"/><Relationship Id="rId9" Type="http://schemas.openxmlformats.org/officeDocument/2006/relationships/image" Target="../media/image202.jpeg"/><Relationship Id="rId14" Type="http://schemas.openxmlformats.org/officeDocument/2006/relationships/image" Target="../media/image207.jpe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18" Type="http://schemas.microsoft.com/office/2007/relationships/hdphoto" Target="../media/hdphoto7.wdp"/><Relationship Id="rId3" Type="http://schemas.microsoft.com/office/2007/relationships/hdphoto" Target="../media/hdphoto1.wdp"/><Relationship Id="rId21" Type="http://schemas.microsoft.com/office/2007/relationships/hdphoto" Target="../media/hdphoto8.wdp"/><Relationship Id="rId7" Type="http://schemas.openxmlformats.org/officeDocument/2006/relationships/image" Target="../media/image10.jpeg"/><Relationship Id="rId12" Type="http://schemas.openxmlformats.org/officeDocument/2006/relationships/image" Target="../media/image13.jpeg"/><Relationship Id="rId17" Type="http://schemas.openxmlformats.org/officeDocument/2006/relationships/image" Target="../media/image16.jpeg"/><Relationship Id="rId2" Type="http://schemas.openxmlformats.org/officeDocument/2006/relationships/image" Target="../media/image7.jpeg"/><Relationship Id="rId16" Type="http://schemas.microsoft.com/office/2007/relationships/hdphoto" Target="../media/hdphoto6.wdp"/><Relationship Id="rId20" Type="http://schemas.openxmlformats.org/officeDocument/2006/relationships/image" Target="../media/image18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microsoft.com/office/2007/relationships/hdphoto" Target="../media/hdphoto4.wdp"/><Relationship Id="rId5" Type="http://schemas.openxmlformats.org/officeDocument/2006/relationships/image" Target="../media/image9.jpeg"/><Relationship Id="rId15" Type="http://schemas.openxmlformats.org/officeDocument/2006/relationships/image" Target="../media/image15.jpeg"/><Relationship Id="rId10" Type="http://schemas.openxmlformats.org/officeDocument/2006/relationships/image" Target="../media/image12.jpeg"/><Relationship Id="rId19" Type="http://schemas.openxmlformats.org/officeDocument/2006/relationships/image" Target="../media/image17.jpeg"/><Relationship Id="rId4" Type="http://schemas.openxmlformats.org/officeDocument/2006/relationships/image" Target="../media/image8.jpeg"/><Relationship Id="rId9" Type="http://schemas.openxmlformats.org/officeDocument/2006/relationships/image" Target="../media/image11.jpeg"/><Relationship Id="rId14" Type="http://schemas.openxmlformats.org/officeDocument/2006/relationships/image" Target="../media/image14.jpe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4.jpeg"/><Relationship Id="rId13" Type="http://schemas.openxmlformats.org/officeDocument/2006/relationships/image" Target="../media/image218.jpeg"/><Relationship Id="rId3" Type="http://schemas.openxmlformats.org/officeDocument/2006/relationships/image" Target="../media/image209.jpeg"/><Relationship Id="rId7" Type="http://schemas.openxmlformats.org/officeDocument/2006/relationships/image" Target="../media/image213.jpeg"/><Relationship Id="rId12" Type="http://schemas.openxmlformats.org/officeDocument/2006/relationships/image" Target="../media/image217.jpeg"/><Relationship Id="rId2" Type="http://schemas.openxmlformats.org/officeDocument/2006/relationships/image" Target="../media/image20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2.jpeg"/><Relationship Id="rId11" Type="http://schemas.openxmlformats.org/officeDocument/2006/relationships/image" Target="../media/image216.jpeg"/><Relationship Id="rId5" Type="http://schemas.openxmlformats.org/officeDocument/2006/relationships/image" Target="../media/image211.jpeg"/><Relationship Id="rId10" Type="http://schemas.microsoft.com/office/2007/relationships/hdphoto" Target="../media/hdphoto51.wdp"/><Relationship Id="rId4" Type="http://schemas.openxmlformats.org/officeDocument/2006/relationships/image" Target="../media/image210.jpeg"/><Relationship Id="rId9" Type="http://schemas.openxmlformats.org/officeDocument/2006/relationships/image" Target="../media/image215.jpeg"/><Relationship Id="rId14" Type="http://schemas.openxmlformats.org/officeDocument/2006/relationships/image" Target="../media/image219.jpeg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6.jpeg"/><Relationship Id="rId13" Type="http://schemas.openxmlformats.org/officeDocument/2006/relationships/image" Target="../media/image231.jpeg"/><Relationship Id="rId3" Type="http://schemas.openxmlformats.org/officeDocument/2006/relationships/image" Target="../media/image221.jpeg"/><Relationship Id="rId7" Type="http://schemas.openxmlformats.org/officeDocument/2006/relationships/image" Target="../media/image225.jpeg"/><Relationship Id="rId12" Type="http://schemas.openxmlformats.org/officeDocument/2006/relationships/image" Target="../media/image230.jpeg"/><Relationship Id="rId2" Type="http://schemas.openxmlformats.org/officeDocument/2006/relationships/image" Target="../media/image220.jpeg"/><Relationship Id="rId16" Type="http://schemas.openxmlformats.org/officeDocument/2006/relationships/image" Target="../media/image23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4.jpeg"/><Relationship Id="rId11" Type="http://schemas.openxmlformats.org/officeDocument/2006/relationships/image" Target="../media/image229.jpeg"/><Relationship Id="rId5" Type="http://schemas.openxmlformats.org/officeDocument/2006/relationships/image" Target="../media/image223.jpeg"/><Relationship Id="rId15" Type="http://schemas.openxmlformats.org/officeDocument/2006/relationships/image" Target="../media/image233.jpeg"/><Relationship Id="rId10" Type="http://schemas.openxmlformats.org/officeDocument/2006/relationships/image" Target="../media/image228.jpeg"/><Relationship Id="rId4" Type="http://schemas.openxmlformats.org/officeDocument/2006/relationships/image" Target="../media/image222.jpeg"/><Relationship Id="rId9" Type="http://schemas.openxmlformats.org/officeDocument/2006/relationships/image" Target="../media/image227.jpeg"/><Relationship Id="rId14" Type="http://schemas.openxmlformats.org/officeDocument/2006/relationships/image" Target="../media/image232.jpe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1.jpeg"/><Relationship Id="rId13" Type="http://schemas.openxmlformats.org/officeDocument/2006/relationships/image" Target="../media/image246.jpeg"/><Relationship Id="rId3" Type="http://schemas.openxmlformats.org/officeDocument/2006/relationships/image" Target="../media/image236.jpeg"/><Relationship Id="rId7" Type="http://schemas.openxmlformats.org/officeDocument/2006/relationships/image" Target="../media/image240.jpeg"/><Relationship Id="rId12" Type="http://schemas.openxmlformats.org/officeDocument/2006/relationships/image" Target="../media/image245.jpeg"/><Relationship Id="rId2" Type="http://schemas.openxmlformats.org/officeDocument/2006/relationships/image" Target="../media/image23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9.jpeg"/><Relationship Id="rId11" Type="http://schemas.openxmlformats.org/officeDocument/2006/relationships/image" Target="../media/image244.jpeg"/><Relationship Id="rId5" Type="http://schemas.openxmlformats.org/officeDocument/2006/relationships/image" Target="../media/image238.jpeg"/><Relationship Id="rId10" Type="http://schemas.openxmlformats.org/officeDocument/2006/relationships/image" Target="../media/image243.jpeg"/><Relationship Id="rId4" Type="http://schemas.openxmlformats.org/officeDocument/2006/relationships/image" Target="../media/image237.jpeg"/><Relationship Id="rId9" Type="http://schemas.openxmlformats.org/officeDocument/2006/relationships/image" Target="../media/image242.jpeg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3.jpeg"/><Relationship Id="rId13" Type="http://schemas.openxmlformats.org/officeDocument/2006/relationships/image" Target="../media/image258.jpeg"/><Relationship Id="rId3" Type="http://schemas.openxmlformats.org/officeDocument/2006/relationships/image" Target="../media/image248.jpeg"/><Relationship Id="rId7" Type="http://schemas.openxmlformats.org/officeDocument/2006/relationships/image" Target="../media/image252.jpeg"/><Relationship Id="rId12" Type="http://schemas.openxmlformats.org/officeDocument/2006/relationships/image" Target="../media/image257.jpeg"/><Relationship Id="rId2" Type="http://schemas.openxmlformats.org/officeDocument/2006/relationships/image" Target="../media/image24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1.jpeg"/><Relationship Id="rId11" Type="http://schemas.openxmlformats.org/officeDocument/2006/relationships/image" Target="../media/image256.jpeg"/><Relationship Id="rId5" Type="http://schemas.openxmlformats.org/officeDocument/2006/relationships/image" Target="../media/image250.jpeg"/><Relationship Id="rId10" Type="http://schemas.openxmlformats.org/officeDocument/2006/relationships/image" Target="../media/image255.jpeg"/><Relationship Id="rId4" Type="http://schemas.openxmlformats.org/officeDocument/2006/relationships/image" Target="../media/image249.jpeg"/><Relationship Id="rId9" Type="http://schemas.openxmlformats.org/officeDocument/2006/relationships/image" Target="../media/image254.jpe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5.jpeg"/><Relationship Id="rId13" Type="http://schemas.openxmlformats.org/officeDocument/2006/relationships/image" Target="../media/image270.jpeg"/><Relationship Id="rId3" Type="http://schemas.openxmlformats.org/officeDocument/2006/relationships/image" Target="../media/image260.jpeg"/><Relationship Id="rId7" Type="http://schemas.openxmlformats.org/officeDocument/2006/relationships/image" Target="../media/image264.jpeg"/><Relationship Id="rId12" Type="http://schemas.openxmlformats.org/officeDocument/2006/relationships/image" Target="../media/image269.jpeg"/><Relationship Id="rId2" Type="http://schemas.openxmlformats.org/officeDocument/2006/relationships/image" Target="../media/image259.jpeg"/><Relationship Id="rId16" Type="http://schemas.openxmlformats.org/officeDocument/2006/relationships/image" Target="../media/image27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3.jpeg"/><Relationship Id="rId11" Type="http://schemas.openxmlformats.org/officeDocument/2006/relationships/image" Target="../media/image268.jpeg"/><Relationship Id="rId5" Type="http://schemas.openxmlformats.org/officeDocument/2006/relationships/image" Target="../media/image262.jpeg"/><Relationship Id="rId15" Type="http://schemas.openxmlformats.org/officeDocument/2006/relationships/image" Target="../media/image272.jpeg"/><Relationship Id="rId10" Type="http://schemas.openxmlformats.org/officeDocument/2006/relationships/image" Target="../media/image267.jpeg"/><Relationship Id="rId4" Type="http://schemas.openxmlformats.org/officeDocument/2006/relationships/image" Target="../media/image261.jpeg"/><Relationship Id="rId9" Type="http://schemas.openxmlformats.org/officeDocument/2006/relationships/image" Target="../media/image266.jpeg"/><Relationship Id="rId14" Type="http://schemas.openxmlformats.org/officeDocument/2006/relationships/image" Target="../media/image271.jpeg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0.jpeg"/><Relationship Id="rId13" Type="http://schemas.openxmlformats.org/officeDocument/2006/relationships/image" Target="../media/image285.jpeg"/><Relationship Id="rId3" Type="http://schemas.openxmlformats.org/officeDocument/2006/relationships/image" Target="../media/image275.jpeg"/><Relationship Id="rId7" Type="http://schemas.openxmlformats.org/officeDocument/2006/relationships/image" Target="../media/image279.jpeg"/><Relationship Id="rId12" Type="http://schemas.openxmlformats.org/officeDocument/2006/relationships/image" Target="../media/image284.jpeg"/><Relationship Id="rId2" Type="http://schemas.openxmlformats.org/officeDocument/2006/relationships/image" Target="../media/image27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8.jpeg"/><Relationship Id="rId11" Type="http://schemas.openxmlformats.org/officeDocument/2006/relationships/image" Target="../media/image283.jpeg"/><Relationship Id="rId5" Type="http://schemas.openxmlformats.org/officeDocument/2006/relationships/image" Target="../media/image277.jpeg"/><Relationship Id="rId10" Type="http://schemas.openxmlformats.org/officeDocument/2006/relationships/image" Target="../media/image282.jpeg"/><Relationship Id="rId4" Type="http://schemas.openxmlformats.org/officeDocument/2006/relationships/image" Target="../media/image276.jpeg"/><Relationship Id="rId9" Type="http://schemas.openxmlformats.org/officeDocument/2006/relationships/image" Target="../media/image281.jpeg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2.jpeg"/><Relationship Id="rId13" Type="http://schemas.openxmlformats.org/officeDocument/2006/relationships/image" Target="../media/image297.jpeg"/><Relationship Id="rId3" Type="http://schemas.openxmlformats.org/officeDocument/2006/relationships/image" Target="../media/image287.jpeg"/><Relationship Id="rId7" Type="http://schemas.openxmlformats.org/officeDocument/2006/relationships/image" Target="../media/image291.jpeg"/><Relationship Id="rId12" Type="http://schemas.openxmlformats.org/officeDocument/2006/relationships/image" Target="../media/image296.jpeg"/><Relationship Id="rId2" Type="http://schemas.openxmlformats.org/officeDocument/2006/relationships/image" Target="../media/image28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0.jpeg"/><Relationship Id="rId11" Type="http://schemas.openxmlformats.org/officeDocument/2006/relationships/image" Target="../media/image295.jpeg"/><Relationship Id="rId5" Type="http://schemas.openxmlformats.org/officeDocument/2006/relationships/image" Target="../media/image289.jpeg"/><Relationship Id="rId15" Type="http://schemas.openxmlformats.org/officeDocument/2006/relationships/image" Target="../media/image299.jpeg"/><Relationship Id="rId10" Type="http://schemas.openxmlformats.org/officeDocument/2006/relationships/image" Target="../media/image294.jpeg"/><Relationship Id="rId4" Type="http://schemas.openxmlformats.org/officeDocument/2006/relationships/image" Target="../media/image288.jpeg"/><Relationship Id="rId9" Type="http://schemas.openxmlformats.org/officeDocument/2006/relationships/image" Target="../media/image293.jpeg"/><Relationship Id="rId14" Type="http://schemas.openxmlformats.org/officeDocument/2006/relationships/image" Target="../media/image298.jpeg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6.jpeg"/><Relationship Id="rId13" Type="http://schemas.microsoft.com/office/2007/relationships/hdphoto" Target="../media/hdphoto52.wdp"/><Relationship Id="rId3" Type="http://schemas.openxmlformats.org/officeDocument/2006/relationships/image" Target="../media/image301.jpeg"/><Relationship Id="rId7" Type="http://schemas.openxmlformats.org/officeDocument/2006/relationships/image" Target="../media/image305.jpeg"/><Relationship Id="rId12" Type="http://schemas.openxmlformats.org/officeDocument/2006/relationships/image" Target="../media/image310.jpeg"/><Relationship Id="rId2" Type="http://schemas.openxmlformats.org/officeDocument/2006/relationships/image" Target="../media/image30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4.jpeg"/><Relationship Id="rId11" Type="http://schemas.openxmlformats.org/officeDocument/2006/relationships/image" Target="../media/image309.jpeg"/><Relationship Id="rId5" Type="http://schemas.openxmlformats.org/officeDocument/2006/relationships/image" Target="../media/image303.jpeg"/><Relationship Id="rId15" Type="http://schemas.microsoft.com/office/2007/relationships/hdphoto" Target="../media/hdphoto53.wdp"/><Relationship Id="rId10" Type="http://schemas.openxmlformats.org/officeDocument/2006/relationships/image" Target="../media/image308.jpeg"/><Relationship Id="rId4" Type="http://schemas.openxmlformats.org/officeDocument/2006/relationships/image" Target="../media/image302.jpeg"/><Relationship Id="rId9" Type="http://schemas.openxmlformats.org/officeDocument/2006/relationships/image" Target="../media/image307.jpeg"/><Relationship Id="rId14" Type="http://schemas.openxmlformats.org/officeDocument/2006/relationships/image" Target="../media/image311.jpeg"/></Relationships>
</file>

<file path=ppt/slides/_rels/slide2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8.jpeg"/><Relationship Id="rId13" Type="http://schemas.openxmlformats.org/officeDocument/2006/relationships/image" Target="../media/image323.jpeg"/><Relationship Id="rId3" Type="http://schemas.openxmlformats.org/officeDocument/2006/relationships/image" Target="../media/image313.jpeg"/><Relationship Id="rId7" Type="http://schemas.openxmlformats.org/officeDocument/2006/relationships/image" Target="../media/image317.jpeg"/><Relationship Id="rId12" Type="http://schemas.openxmlformats.org/officeDocument/2006/relationships/image" Target="../media/image322.jpeg"/><Relationship Id="rId2" Type="http://schemas.openxmlformats.org/officeDocument/2006/relationships/image" Target="../media/image31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6.jpeg"/><Relationship Id="rId11" Type="http://schemas.openxmlformats.org/officeDocument/2006/relationships/image" Target="../media/image321.jpeg"/><Relationship Id="rId5" Type="http://schemas.openxmlformats.org/officeDocument/2006/relationships/image" Target="../media/image315.jpeg"/><Relationship Id="rId10" Type="http://schemas.openxmlformats.org/officeDocument/2006/relationships/image" Target="../media/image320.jpeg"/><Relationship Id="rId4" Type="http://schemas.openxmlformats.org/officeDocument/2006/relationships/image" Target="../media/image314.jpeg"/><Relationship Id="rId9" Type="http://schemas.openxmlformats.org/officeDocument/2006/relationships/image" Target="../media/image319.jpeg"/></Relationships>
</file>

<file path=ppt/slides/_rels/slide2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8.jpeg"/><Relationship Id="rId13" Type="http://schemas.openxmlformats.org/officeDocument/2006/relationships/image" Target="../media/image331.jpeg"/><Relationship Id="rId18" Type="http://schemas.openxmlformats.org/officeDocument/2006/relationships/image" Target="../media/image334.jpeg"/><Relationship Id="rId3" Type="http://schemas.microsoft.com/office/2007/relationships/hdphoto" Target="../media/hdphoto54.wdp"/><Relationship Id="rId21" Type="http://schemas.microsoft.com/office/2007/relationships/hdphoto" Target="../media/hdphoto61.wdp"/><Relationship Id="rId7" Type="http://schemas.openxmlformats.org/officeDocument/2006/relationships/image" Target="../media/image327.jpeg"/><Relationship Id="rId12" Type="http://schemas.openxmlformats.org/officeDocument/2006/relationships/image" Target="../media/image330.jpeg"/><Relationship Id="rId17" Type="http://schemas.openxmlformats.org/officeDocument/2006/relationships/image" Target="../media/image333.jpeg"/><Relationship Id="rId2" Type="http://schemas.openxmlformats.org/officeDocument/2006/relationships/image" Target="../media/image324.jpeg"/><Relationship Id="rId16" Type="http://schemas.microsoft.com/office/2007/relationships/hdphoto" Target="../media/hdphoto59.wdp"/><Relationship Id="rId20" Type="http://schemas.openxmlformats.org/officeDocument/2006/relationships/image" Target="../media/image33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6.jpeg"/><Relationship Id="rId11" Type="http://schemas.microsoft.com/office/2007/relationships/hdphoto" Target="../media/hdphoto57.wdp"/><Relationship Id="rId5" Type="http://schemas.microsoft.com/office/2007/relationships/hdphoto" Target="../media/hdphoto55.wdp"/><Relationship Id="rId15" Type="http://schemas.openxmlformats.org/officeDocument/2006/relationships/image" Target="../media/image332.jpeg"/><Relationship Id="rId10" Type="http://schemas.openxmlformats.org/officeDocument/2006/relationships/image" Target="../media/image329.jpeg"/><Relationship Id="rId19" Type="http://schemas.microsoft.com/office/2007/relationships/hdphoto" Target="../media/hdphoto60.wdp"/><Relationship Id="rId4" Type="http://schemas.openxmlformats.org/officeDocument/2006/relationships/image" Target="../media/image325.jpeg"/><Relationship Id="rId9" Type="http://schemas.microsoft.com/office/2007/relationships/hdphoto" Target="../media/hdphoto56.wdp"/><Relationship Id="rId14" Type="http://schemas.microsoft.com/office/2007/relationships/hdphoto" Target="../media/hdphoto58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1.wdp"/><Relationship Id="rId13" Type="http://schemas.microsoft.com/office/2007/relationships/hdphoto" Target="../media/hdphoto13.wdp"/><Relationship Id="rId18" Type="http://schemas.microsoft.com/office/2007/relationships/hdphoto" Target="../media/hdphoto15.wdp"/><Relationship Id="rId3" Type="http://schemas.microsoft.com/office/2007/relationships/hdphoto" Target="../media/hdphoto9.wdp"/><Relationship Id="rId21" Type="http://schemas.openxmlformats.org/officeDocument/2006/relationships/image" Target="../media/image30.jpeg"/><Relationship Id="rId7" Type="http://schemas.openxmlformats.org/officeDocument/2006/relationships/image" Target="../media/image22.jpeg"/><Relationship Id="rId12" Type="http://schemas.openxmlformats.org/officeDocument/2006/relationships/image" Target="../media/image25.jpeg"/><Relationship Id="rId17" Type="http://schemas.openxmlformats.org/officeDocument/2006/relationships/image" Target="../media/image28.jpeg"/><Relationship Id="rId2" Type="http://schemas.openxmlformats.org/officeDocument/2006/relationships/image" Target="../media/image19.jpeg"/><Relationship Id="rId16" Type="http://schemas.openxmlformats.org/officeDocument/2006/relationships/image" Target="../media/image27.jpeg"/><Relationship Id="rId20" Type="http://schemas.microsoft.com/office/2007/relationships/hdphoto" Target="../media/hdphoto16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jpeg"/><Relationship Id="rId11" Type="http://schemas.openxmlformats.org/officeDocument/2006/relationships/image" Target="../media/image24.jpeg"/><Relationship Id="rId5" Type="http://schemas.microsoft.com/office/2007/relationships/hdphoto" Target="../media/hdphoto10.wdp"/><Relationship Id="rId15" Type="http://schemas.microsoft.com/office/2007/relationships/hdphoto" Target="../media/hdphoto14.wdp"/><Relationship Id="rId10" Type="http://schemas.microsoft.com/office/2007/relationships/hdphoto" Target="../media/hdphoto12.wdp"/><Relationship Id="rId19" Type="http://schemas.openxmlformats.org/officeDocument/2006/relationships/image" Target="../media/image29.jpeg"/><Relationship Id="rId4" Type="http://schemas.openxmlformats.org/officeDocument/2006/relationships/image" Target="../media/image20.jpeg"/><Relationship Id="rId9" Type="http://schemas.openxmlformats.org/officeDocument/2006/relationships/image" Target="../media/image23.jpeg"/><Relationship Id="rId14" Type="http://schemas.openxmlformats.org/officeDocument/2006/relationships/image" Target="../media/image26.jpeg"/></Relationships>
</file>

<file path=ppt/slides/_rels/slide3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0.jpeg"/><Relationship Id="rId13" Type="http://schemas.openxmlformats.org/officeDocument/2006/relationships/image" Target="../media/image345.jpeg"/><Relationship Id="rId18" Type="http://schemas.openxmlformats.org/officeDocument/2006/relationships/image" Target="../media/image350.jpeg"/><Relationship Id="rId3" Type="http://schemas.openxmlformats.org/officeDocument/2006/relationships/image" Target="../media/image337.jpeg"/><Relationship Id="rId7" Type="http://schemas.openxmlformats.org/officeDocument/2006/relationships/image" Target="../media/image339.jpeg"/><Relationship Id="rId12" Type="http://schemas.openxmlformats.org/officeDocument/2006/relationships/image" Target="../media/image344.jpeg"/><Relationship Id="rId17" Type="http://schemas.openxmlformats.org/officeDocument/2006/relationships/image" Target="../media/image349.jpeg"/><Relationship Id="rId2" Type="http://schemas.openxmlformats.org/officeDocument/2006/relationships/image" Target="../media/image336.jpeg"/><Relationship Id="rId16" Type="http://schemas.openxmlformats.org/officeDocument/2006/relationships/image" Target="../media/image348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63.wdp"/><Relationship Id="rId11" Type="http://schemas.openxmlformats.org/officeDocument/2006/relationships/image" Target="../media/image343.jpeg"/><Relationship Id="rId5" Type="http://schemas.openxmlformats.org/officeDocument/2006/relationships/image" Target="../media/image338.jpeg"/><Relationship Id="rId15" Type="http://schemas.openxmlformats.org/officeDocument/2006/relationships/image" Target="../media/image347.jpeg"/><Relationship Id="rId10" Type="http://schemas.openxmlformats.org/officeDocument/2006/relationships/image" Target="../media/image342.jpeg"/><Relationship Id="rId4" Type="http://schemas.microsoft.com/office/2007/relationships/hdphoto" Target="../media/hdphoto62.wdp"/><Relationship Id="rId9" Type="http://schemas.openxmlformats.org/officeDocument/2006/relationships/image" Target="../media/image341.jpeg"/><Relationship Id="rId14" Type="http://schemas.openxmlformats.org/officeDocument/2006/relationships/image" Target="../media/image346.jpeg"/></Relationships>
</file>

<file path=ppt/slides/_rels/slide3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6.jpeg"/><Relationship Id="rId13" Type="http://schemas.microsoft.com/office/2007/relationships/hdphoto" Target="../media/hdphoto66.wdp"/><Relationship Id="rId18" Type="http://schemas.microsoft.com/office/2007/relationships/hdphoto" Target="../media/hdphoto68.wdp"/><Relationship Id="rId26" Type="http://schemas.microsoft.com/office/2007/relationships/hdphoto" Target="../media/hdphoto71.wdp"/><Relationship Id="rId3" Type="http://schemas.openxmlformats.org/officeDocument/2006/relationships/image" Target="../media/image352.jpeg"/><Relationship Id="rId21" Type="http://schemas.microsoft.com/office/2007/relationships/hdphoto" Target="../media/hdphoto69.wdp"/><Relationship Id="rId7" Type="http://schemas.microsoft.com/office/2007/relationships/hdphoto" Target="../media/hdphoto64.wdp"/><Relationship Id="rId12" Type="http://schemas.openxmlformats.org/officeDocument/2006/relationships/image" Target="../media/image359.jpeg"/><Relationship Id="rId17" Type="http://schemas.openxmlformats.org/officeDocument/2006/relationships/image" Target="../media/image362.jpeg"/><Relationship Id="rId25" Type="http://schemas.openxmlformats.org/officeDocument/2006/relationships/image" Target="../media/image367.jpeg"/><Relationship Id="rId2" Type="http://schemas.openxmlformats.org/officeDocument/2006/relationships/image" Target="../media/image351.jpeg"/><Relationship Id="rId16" Type="http://schemas.microsoft.com/office/2007/relationships/hdphoto" Target="../media/hdphoto67.wdp"/><Relationship Id="rId20" Type="http://schemas.openxmlformats.org/officeDocument/2006/relationships/image" Target="../media/image36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5.jpeg"/><Relationship Id="rId11" Type="http://schemas.openxmlformats.org/officeDocument/2006/relationships/image" Target="../media/image358.jpeg"/><Relationship Id="rId24" Type="http://schemas.openxmlformats.org/officeDocument/2006/relationships/image" Target="../media/image366.jpeg"/><Relationship Id="rId5" Type="http://schemas.openxmlformats.org/officeDocument/2006/relationships/image" Target="../media/image354.jpeg"/><Relationship Id="rId15" Type="http://schemas.openxmlformats.org/officeDocument/2006/relationships/image" Target="../media/image361.jpeg"/><Relationship Id="rId23" Type="http://schemas.microsoft.com/office/2007/relationships/hdphoto" Target="../media/hdphoto70.wdp"/><Relationship Id="rId28" Type="http://schemas.microsoft.com/office/2007/relationships/hdphoto" Target="../media/hdphoto72.wdp"/><Relationship Id="rId10" Type="http://schemas.openxmlformats.org/officeDocument/2006/relationships/image" Target="../media/image357.jpeg"/><Relationship Id="rId19" Type="http://schemas.openxmlformats.org/officeDocument/2006/relationships/image" Target="../media/image363.jpeg"/><Relationship Id="rId4" Type="http://schemas.openxmlformats.org/officeDocument/2006/relationships/image" Target="../media/image353.jpeg"/><Relationship Id="rId9" Type="http://schemas.microsoft.com/office/2007/relationships/hdphoto" Target="../media/hdphoto65.wdp"/><Relationship Id="rId14" Type="http://schemas.openxmlformats.org/officeDocument/2006/relationships/image" Target="../media/image360.jpeg"/><Relationship Id="rId22" Type="http://schemas.openxmlformats.org/officeDocument/2006/relationships/image" Target="../media/image365.jpeg"/><Relationship Id="rId27" Type="http://schemas.openxmlformats.org/officeDocument/2006/relationships/image" Target="../media/image368.jpe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9.wdp"/><Relationship Id="rId13" Type="http://schemas.microsoft.com/office/2007/relationships/hdphoto" Target="../media/hdphoto21.wdp"/><Relationship Id="rId18" Type="http://schemas.microsoft.com/office/2007/relationships/hdphoto" Target="../media/hdphoto23.wdp"/><Relationship Id="rId3" Type="http://schemas.microsoft.com/office/2007/relationships/hdphoto" Target="../media/hdphoto17.wdp"/><Relationship Id="rId21" Type="http://schemas.microsoft.com/office/2007/relationships/hdphoto" Target="../media/hdphoto24.wdp"/><Relationship Id="rId7" Type="http://schemas.openxmlformats.org/officeDocument/2006/relationships/image" Target="../media/image34.jpeg"/><Relationship Id="rId12" Type="http://schemas.openxmlformats.org/officeDocument/2006/relationships/image" Target="../media/image37.jpeg"/><Relationship Id="rId17" Type="http://schemas.openxmlformats.org/officeDocument/2006/relationships/image" Target="../media/image40.jpeg"/><Relationship Id="rId2" Type="http://schemas.openxmlformats.org/officeDocument/2006/relationships/image" Target="../media/image31.jpeg"/><Relationship Id="rId16" Type="http://schemas.microsoft.com/office/2007/relationships/hdphoto" Target="../media/hdphoto22.wdp"/><Relationship Id="rId20" Type="http://schemas.openxmlformats.org/officeDocument/2006/relationships/image" Target="../media/image42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18.wdp"/><Relationship Id="rId11" Type="http://schemas.microsoft.com/office/2007/relationships/hdphoto" Target="../media/hdphoto20.wdp"/><Relationship Id="rId5" Type="http://schemas.openxmlformats.org/officeDocument/2006/relationships/image" Target="../media/image33.jpeg"/><Relationship Id="rId15" Type="http://schemas.openxmlformats.org/officeDocument/2006/relationships/image" Target="../media/image39.jpeg"/><Relationship Id="rId10" Type="http://schemas.openxmlformats.org/officeDocument/2006/relationships/image" Target="../media/image36.jpeg"/><Relationship Id="rId19" Type="http://schemas.openxmlformats.org/officeDocument/2006/relationships/image" Target="../media/image41.jpeg"/><Relationship Id="rId4" Type="http://schemas.openxmlformats.org/officeDocument/2006/relationships/image" Target="../media/image32.jpeg"/><Relationship Id="rId9" Type="http://schemas.openxmlformats.org/officeDocument/2006/relationships/image" Target="../media/image35.jpeg"/><Relationship Id="rId14" Type="http://schemas.openxmlformats.org/officeDocument/2006/relationships/image" Target="../media/image38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jpeg"/><Relationship Id="rId13" Type="http://schemas.openxmlformats.org/officeDocument/2006/relationships/image" Target="../media/image53.jpeg"/><Relationship Id="rId3" Type="http://schemas.openxmlformats.org/officeDocument/2006/relationships/image" Target="../media/image44.jpeg"/><Relationship Id="rId7" Type="http://schemas.openxmlformats.org/officeDocument/2006/relationships/image" Target="../media/image48.jpeg"/><Relationship Id="rId12" Type="http://schemas.openxmlformats.org/officeDocument/2006/relationships/image" Target="../media/image52.jpe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jpeg"/><Relationship Id="rId11" Type="http://schemas.openxmlformats.org/officeDocument/2006/relationships/image" Target="../media/image51.jpeg"/><Relationship Id="rId5" Type="http://schemas.openxmlformats.org/officeDocument/2006/relationships/image" Target="../media/image46.jpeg"/><Relationship Id="rId10" Type="http://schemas.openxmlformats.org/officeDocument/2006/relationships/image" Target="../media/image50.jpeg"/><Relationship Id="rId4" Type="http://schemas.openxmlformats.org/officeDocument/2006/relationships/image" Target="../media/image45.jpeg"/><Relationship Id="rId9" Type="http://schemas.microsoft.com/office/2007/relationships/hdphoto" Target="../media/hdphoto25.wdp"/><Relationship Id="rId14" Type="http://schemas.openxmlformats.org/officeDocument/2006/relationships/image" Target="../media/image54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jpeg"/><Relationship Id="rId7" Type="http://schemas.openxmlformats.org/officeDocument/2006/relationships/image" Target="../media/image60.jpeg"/><Relationship Id="rId2" Type="http://schemas.openxmlformats.org/officeDocument/2006/relationships/image" Target="../media/image5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jpeg"/><Relationship Id="rId5" Type="http://schemas.openxmlformats.org/officeDocument/2006/relationships/image" Target="../media/image58.jpeg"/><Relationship Id="rId4" Type="http://schemas.openxmlformats.org/officeDocument/2006/relationships/image" Target="../media/image57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jpeg"/><Relationship Id="rId13" Type="http://schemas.openxmlformats.org/officeDocument/2006/relationships/image" Target="../media/image72.jpeg"/><Relationship Id="rId3" Type="http://schemas.openxmlformats.org/officeDocument/2006/relationships/image" Target="../media/image62.jpeg"/><Relationship Id="rId7" Type="http://schemas.openxmlformats.org/officeDocument/2006/relationships/image" Target="../media/image66.jpeg"/><Relationship Id="rId12" Type="http://schemas.openxmlformats.org/officeDocument/2006/relationships/image" Target="../media/image71.jpeg"/><Relationship Id="rId2" Type="http://schemas.openxmlformats.org/officeDocument/2006/relationships/image" Target="../media/image6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5.jpeg"/><Relationship Id="rId11" Type="http://schemas.openxmlformats.org/officeDocument/2006/relationships/image" Target="../media/image70.jpeg"/><Relationship Id="rId5" Type="http://schemas.openxmlformats.org/officeDocument/2006/relationships/image" Target="../media/image64.jpeg"/><Relationship Id="rId10" Type="http://schemas.openxmlformats.org/officeDocument/2006/relationships/image" Target="../media/image69.jpeg"/><Relationship Id="rId4" Type="http://schemas.openxmlformats.org/officeDocument/2006/relationships/image" Target="../media/image63.jpeg"/><Relationship Id="rId9" Type="http://schemas.openxmlformats.org/officeDocument/2006/relationships/image" Target="../media/image68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jpeg"/><Relationship Id="rId13" Type="http://schemas.openxmlformats.org/officeDocument/2006/relationships/image" Target="../media/image84.jpeg"/><Relationship Id="rId3" Type="http://schemas.openxmlformats.org/officeDocument/2006/relationships/image" Target="../media/image74.jpeg"/><Relationship Id="rId7" Type="http://schemas.openxmlformats.org/officeDocument/2006/relationships/image" Target="../media/image78.jpeg"/><Relationship Id="rId12" Type="http://schemas.openxmlformats.org/officeDocument/2006/relationships/image" Target="../media/image83.jpeg"/><Relationship Id="rId2" Type="http://schemas.openxmlformats.org/officeDocument/2006/relationships/image" Target="../media/image7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7.jpeg"/><Relationship Id="rId11" Type="http://schemas.openxmlformats.org/officeDocument/2006/relationships/image" Target="../media/image82.jpeg"/><Relationship Id="rId5" Type="http://schemas.openxmlformats.org/officeDocument/2006/relationships/image" Target="../media/image76.jpeg"/><Relationship Id="rId10" Type="http://schemas.openxmlformats.org/officeDocument/2006/relationships/image" Target="../media/image81.jpeg"/><Relationship Id="rId4" Type="http://schemas.openxmlformats.org/officeDocument/2006/relationships/image" Target="../media/image75.jpeg"/><Relationship Id="rId9" Type="http://schemas.openxmlformats.org/officeDocument/2006/relationships/image" Target="../media/image80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90.jpeg"/><Relationship Id="rId13" Type="http://schemas.microsoft.com/office/2007/relationships/hdphoto" Target="../media/hdphoto28.wdp"/><Relationship Id="rId3" Type="http://schemas.openxmlformats.org/officeDocument/2006/relationships/image" Target="../media/image86.jpeg"/><Relationship Id="rId7" Type="http://schemas.openxmlformats.org/officeDocument/2006/relationships/image" Target="../media/image89.jpeg"/><Relationship Id="rId12" Type="http://schemas.openxmlformats.org/officeDocument/2006/relationships/image" Target="../media/image93.jpeg"/><Relationship Id="rId17" Type="http://schemas.microsoft.com/office/2007/relationships/hdphoto" Target="../media/hdphoto29.wdp"/><Relationship Id="rId2" Type="http://schemas.openxmlformats.org/officeDocument/2006/relationships/image" Target="../media/image85.jpeg"/><Relationship Id="rId16" Type="http://schemas.openxmlformats.org/officeDocument/2006/relationships/image" Target="../media/image9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8.jpeg"/><Relationship Id="rId11" Type="http://schemas.openxmlformats.org/officeDocument/2006/relationships/image" Target="../media/image92.jpeg"/><Relationship Id="rId5" Type="http://schemas.microsoft.com/office/2007/relationships/hdphoto" Target="../media/hdphoto26.wdp"/><Relationship Id="rId15" Type="http://schemas.openxmlformats.org/officeDocument/2006/relationships/image" Target="../media/image95.jpeg"/><Relationship Id="rId10" Type="http://schemas.openxmlformats.org/officeDocument/2006/relationships/image" Target="../media/image91.jpeg"/><Relationship Id="rId4" Type="http://schemas.openxmlformats.org/officeDocument/2006/relationships/image" Target="../media/image87.jpeg"/><Relationship Id="rId9" Type="http://schemas.microsoft.com/office/2007/relationships/hdphoto" Target="../media/hdphoto27.wdp"/><Relationship Id="rId14" Type="http://schemas.openxmlformats.org/officeDocument/2006/relationships/image" Target="../media/image9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 descr="G:\13.06.25 U2OS siMDC1-PID3.mdb\U2OSsiCTL-P-ID3-0hr-1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376" y="620888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G:\13.06.25 U2OS siMDC1-PID3.mdb\U2OSsiCTL-P-ID3-0hr-1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376" y="4653336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G:\13.06.25 U2OS siMDC1-PID3.mdb\U2OSsiCTL-P-ID3-0hr-1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3106" y="2637112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G:\13.06.25 U2OS siMDC1-PID3.mdb\U2OSsiCTL-P-ID3-0hr-2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6563" y="620888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G:\13.06.25 U2OS siMDC1-PID3.mdb\U2OSsiCTL-P-ID3-0hr-2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5216" y="4653336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G:\13.06.25 U2OS siMDC1-PID3.mdb\U2OSsiCTL-P-ID3-0hr-2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5216" y="2637112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692766" y="660072"/>
            <a:ext cx="18966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 Gy-0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794304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G:\13.06.25 U2OS siMDC1-PID3.mdb\U2OSsiMDC1-P-ID3-6hr-3_c1+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8264" y="4588301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3" name="Picture 3" descr="G:\13.06.25 U2OS siMDC1-PID3.mdb\U2OSsiMDC1-P-ID3-6hr-3_c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8264" y="242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4" name="Picture 4" descr="G:\13.06.25 U2OS siMDC1-PID3.mdb\U2OSsiMDC1-P-ID3-6hr-4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26064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5" name="Picture 5" descr="G:\13.06.25 U2OS siMDC1-PID3.mdb\U2OSsiMDC1-P-ID3-6hr-4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456626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6" name="Picture 6" descr="G:\13.06.25 U2OS siMDC1-PID3.mdb\U2OSsiMDC1-P-ID3-6hr-4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242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7" name="Picture 7" descr="G:\13.06.25 U2OS siMDC1-PID3.mdb\U2OSsiMDC1-P-ID3-6hr-1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792" y="26064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8" name="Picture 8" descr="G:\13.06.25 U2OS siMDC1-PID3.mdb\U2OSsiMDC1-P-ID3-6hr-1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792" y="457021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9" name="Picture 9" descr="G:\13.06.25 U2OS siMDC1-PID3.mdb\U2OSsiMDC1-P-ID3-6hr-1_c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792" y="242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0" name="Picture 10" descr="G:\13.06.25 U2OS siMDC1-PID3.mdb\U2OSsiMDC1-P-ID3-6hr-2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1403" y="26064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1" name="Picture 11" descr="G:\13.06.25 U2OS siMDC1-PID3.mdb\U2OSsiMDC1-P-ID3-6hr-2_c1+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457021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2" name="Picture 12" descr="G:\13.06.25 U2OS siMDC1-PID3.mdb\U2OSsiMDC1-P-ID3-6hr-2_c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242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3" name="Picture 13" descr="G:\13.06.25 U2OS siMDC1-PID3.mdb\U2OSsiMDC1-P-ID3-6hr-3_c1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8264" y="18864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232411" y="194335"/>
            <a:ext cx="22413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3h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50666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G:\13.06.25 U2OS siMDC1-PID3.mdb\사진\U2OSsiCTL-P-ID3-0hr-crop2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8144" y="47667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G:\13.06.25 U2OS siMDC1-PID3.mdb\사진\U2OSsiCTL-P-ID3-0hr-crop2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8144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G:\13.06.25 U2OS siMDC1-PID3.mdb\사진\U2OSsiCTL-P-ID3-0hr-crop2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8144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G:\13.06.25 U2OS siMDC1-PID3.mdb\사진\U2OSsiCTL-P-ID3-0hr-crop1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7904" y="47667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G:\13.06.25 U2OS siMDC1-PID3.mdb\사진\U2OSsiCTL-P-ID3-0hr-crop1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7904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G:\13.06.25 U2OS siMDC1-PID3.mdb\사진\U2OSsiCTL-P-ID3-0hr-crop1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7904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692766" y="660072"/>
            <a:ext cx="18966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Gy-0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18759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G:\13.06.25 U2OS siMDC1-PID3.mdb\사진\U2OSsiCTL-P-ID3-30min-crop1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2495183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G:\13.06.25 U2OS siMDC1-PID3.mdb\사진\U2OSsiCTL-P-ID3-30min-crop2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34444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G:\13.06.25 U2OS siMDC1-PID3.mdb\사진\U2OSsiCTL-P-ID3-30min-crop2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8900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G:\13.06.25 U2OS siMDC1-PID3.mdb\사진\U2OSsiCTL-P-ID3-30min-crop2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8900" y="249289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G:\13.06.25 U2OS siMDC1-PID3.mdb\사진\U2OSsiCTL-P-ID3-30min-crop3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37785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G:\13.06.25 U2OS siMDC1-PID3.mdb\사진\U2OSsiCTL-P-ID3-30min-crop3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G:\13.06.25 U2OS siMDC1-PID3.mdb\사진\U2OSsiCTL-P-ID3-30min-crop3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249289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G:\13.06.25 U2OS siMDC1-PID3.mdb\사진\U2OSsiCTL-P-ID3-30min-crop4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34444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G:\13.06.25 U2OS siMDC1-PID3.mdb\사진\U2OSsiCTL-P-ID3-30min-crop4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9" name="Picture 11" descr="G:\13.06.25 U2OS siMDC1-PID3.mdb\사진\U2OSsiCTL-P-ID3-30min-crop4_c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249289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0" name="Picture 12" descr="G:\13.06.25 U2OS siMDC1-PID3.mdb\사진\U2OSsiCTL-P-ID3-30min-crop1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33265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1" name="Picture 13" descr="G:\13.06.25 U2OS siMDC1-PID3.mdb\사진\U2OSsiCTL-P-ID3-30min-crop1_c1+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6391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692766" y="660072"/>
            <a:ext cx="18966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20min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187596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G:\13.06.25 U2OS siMDC1-PID3.mdb\사진\U2OSsiCTL-P-ID3-1hr-crop2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6496" y="260932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G:\13.06.25 U2OS siMDC1-PID3.mdb\사진\U2OSsiCTL-P-ID3-1hr-crop3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9792" y="453471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G:\13.06.25 U2OS siMDC1-PID3.mdb\사진\U2OSsiCTL-P-ID3-1hr-crop3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7650" y="476136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G:\13.06.25 U2OS siMDC1-PID3.mdb\사진\U2OSsiCTL-P-ID3-1hr-crop3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7650" y="260112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G:\13.06.25 U2OS siMDC1-PID3.mdb\사진\U2OSsiCTL-P-ID3-1hr-crop4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8024" y="44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9" name="Picture 7" descr="G:\13.06.25 U2OS siMDC1-PID3.mdb\사진\U2OSsiCTL-P-ID3-1hr-crop4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6954" y="476136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 descr="G:\13.06.25 U2OS siMDC1-PID3.mdb\사진\U2OSsiCTL-P-ID3-1hr-crop4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8024" y="260112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1" name="Picture 9" descr="G:\13.06.25 U2OS siMDC1-PID3.mdb\사진\U2OSsiCTL-P-ID3-1hr-crop1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2712" y="44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2" name="Picture 10" descr="G:\13.06.25 U2OS siMDC1-PID3.mdb\사진\U2OSsiCTL-P-ID3-1hr-crop1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6256" y="476136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3" name="Picture 11" descr="G:\13.06.25 U2OS siMDC1-PID3.mdb\사진\U2OSsiCTL-P-ID3-1hr-crop1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6256" y="260112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 descr="G:\13.06.25 U2OS siMDC1-PID3.mdb\사진\U2OSsiCTL-P-ID3-1hr-crop2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6496" y="4324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5" name="Picture 13" descr="G:\13.06.25 U2OS siMDC1-PID3.mdb\사진\U2OSsiCTL-P-ID3-1hr-crop2_c1+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6496" y="4736319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692766" y="660072"/>
            <a:ext cx="18966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 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40min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187596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G:\13.06.25 U2OS siMDC1-PID3.mdb\사진\U2OSsiCTL-P-ID3-3hr-crop3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4506" y="601553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G:\13.06.25 U2OS siMDC1-PID3.mdb\사진\U2OSsiCTL-P-ID3-3hr-crop3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475748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G:\13.06.25 U2OS siMDC1-PID3.mdb\사진\U2OSsiCTL-P-ID3-3hr-crop3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2707221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G:\13.06.25 U2OS siMDC1-PID3.mdb\사진\U2OSsiCTL-P-ID3-3hr-crop4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3597" y="601553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G:\13.06.25 U2OS siMDC1-PID3.mdb\사진\U2OSsiCTL-P-ID3-3hr-crop4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97958" y="476136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G:\13.06.25 U2OS siMDC1-PID3.mdb\사진\U2OSsiCTL-P-ID3-3hr-crop4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5816" y="270282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8" descr="G:\13.06.25 U2OS siMDC1-PID3.mdb\사진\U2OSsiCTL-P-ID3-3hr-crop1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048" y="601553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5" name="Picture 9" descr="G:\13.06.25 U2OS siMDC1-PID3.mdb\사진\U2OSsiCTL-P-ID3-3hr-crop1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048" y="475748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6" name="Picture 10" descr="G:\13.06.25 U2OS siMDC1-PID3.mdb\사진\U2OSsiCTL-P-ID3-3hr-crop1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048" y="270282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7" name="Picture 11" descr="G:\13.06.25 U2OS siMDC1-PID3.mdb\사진\U2OSsiCTL-P-ID3-3hr-crop2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2280" y="58187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8" name="Picture 12" descr="G:\13.06.25 U2OS siMDC1-PID3.mdb\사진\U2OSsiCTL-P-ID3-3hr-crop2_c1+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8846" y="4741793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9" name="Picture 13" descr="G:\13.06.25 U2OS siMDC1-PID3.mdb\사진\U2OSsiCTL-P-ID3-3hr-crop2_c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2280" y="267021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692765" y="660072"/>
            <a:ext cx="18966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 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1hr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187596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G:\13.06.25 U2OS siMDC1-PID3.mdb\사진\U2OSsiCTL-P-ID3-6hr-crop2_c1+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2874" y="468677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G:\13.06.25 U2OS siMDC1-PID3.mdb\사진\U2OSsiCTL-P-ID3-6hr-crop2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2874" y="249289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G:\13.06.25 U2OS siMDC1-PID3.mdb\사진\U2OSsiCTL-P-ID3-6hr-crop3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33265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G:\13.06.25 U2OS siMDC1-PID3.mdb\사진\U2OSsiCTL-P-ID3-6hr-crop3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4628609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6" name="Picture 6" descr="G:\13.06.25 U2OS siMDC1-PID3.mdb\사진\U2OSsiCTL-P-ID3-6hr-crop3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249289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7" name="Picture 7" descr="G:\13.06.25 U2OS siMDC1-PID3.mdb\사진\U2OSsiCTL-P-ID3-6hr-crop4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5776" y="33265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8" name="Picture 8" descr="G:\13.06.25 U2OS siMDC1-PID3.mdb\사진\U2OSsiCTL-P-ID3-6hr-crop4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0885" y="4628609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9" name="Picture 9" descr="G:\13.06.25 U2OS siMDC1-PID3.mdb\사진\U2OSsiCTL-P-ID3-6hr-crop4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5776" y="249289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0" name="Picture 10" descr="G:\13.06.25 U2OS siMDC1-PID3.mdb\사진\U2OSsiCTL-P-ID3-6hr-crop1_c1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9228" y="33265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1" name="Picture 11" descr="G:\13.06.25 U2OS siMDC1-PID3.mdb\사진\U2OSsiCTL-P-ID3-6hr-crop1_c1+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9228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2" name="Picture 12" descr="G:\13.06.25 U2OS siMDC1-PID3.mdb\사진\U2OSsiCTL-P-ID3-6hr-crop1_c2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008" y="249289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3" name="Picture 13" descr="G:\13.06.25 U2OS siMDC1-PID3.mdb\사진\U2OSsiCTL-P-ID3-6hr-crop2_c1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21247" y="33265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692765" y="660072"/>
            <a:ext cx="18966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 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3hr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18759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G:\13.06.25 U2OS siMDC1-PID3.mdb\사진\U2OSsiMDC1-P-ID3-0hr-crop1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793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G:\13.06.25 U2OS siMDC1-PID3.mdb\사진\U2OSsiMDC1-P-ID3-0hr-crop2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1617" y="47667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G:\13.06.25 U2OS siMDC1-PID3.mdb\사진\U2OSsiMDC1-P-ID3-0hr-crop2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1617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G:\13.06.25 U2OS siMDC1-PID3.mdb\사진\U2OSsiMDC1-P-ID3-0hr-crop2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 descr="G:\13.06.25 U2OS siMDC1-PID3.mdb\사진\U2OSsiMDC1-P-ID3-0hr-crop1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47667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1" name="Picture 7" descr="G:\13.06.25 U2OS siMDC1-PID3.mdb\사진\U2OSsiMDC1-P-ID3-0hr-crop1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520443" y="660072"/>
            <a:ext cx="22413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Gy-0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187596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163852" y="748698"/>
            <a:ext cx="8872644" cy="5416606"/>
            <a:chOff x="-180528" y="748698"/>
            <a:chExt cx="9304692" cy="5819518"/>
          </a:xfrm>
        </p:grpSpPr>
        <p:pic>
          <p:nvPicPr>
            <p:cNvPr id="7179" name="Picture 11" descr="G:\13.06.25 U2OS siMDC1-PID3.mdb\사진\U2OSsiMDC1-P-ID3-30min-crop2_c1+2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64088" y="775105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81" name="Picture 13" descr="G:\13.06.25 U2OS siMDC1-PID3.mdb\사진\U2OSsiMDC1-P-ID3-30min-crop3_c1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104" y="748698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" name="그룹 1"/>
            <p:cNvGrpSpPr/>
            <p:nvPr/>
          </p:nvGrpSpPr>
          <p:grpSpPr>
            <a:xfrm>
              <a:off x="-180528" y="817879"/>
              <a:ext cx="9304692" cy="5750337"/>
              <a:chOff x="-180528" y="817879"/>
              <a:chExt cx="9304692" cy="5750337"/>
            </a:xfrm>
          </p:grpSpPr>
          <p:pic>
            <p:nvPicPr>
              <p:cNvPr id="7170" name="Picture 2" descr="G:\13.06.25 U2OS siMDC1-PID3.mdb\사진\U2OSsiMDC1-P-ID3-30min-crop4_c1+2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324164" y="4743907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71" name="Picture 3" descr="G:\13.06.25 U2OS siMDC1-PID3.mdb\사진\U2OSsiMDC1-P-ID3-30min-crop4_c2.jpg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308504" y="2744276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72" name="Picture 4" descr="G:\13.06.25 U2OS siMDC1-PID3.mdb\사진\U2OSsiMDC1-P-ID3-30min-crop10_c1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80528" y="836912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73" name="Picture 5" descr="G:\13.06.25 U2OS siMDC1-PID3.mdb\사진\U2OSsiMDC1-P-ID3-30min-crop10_c1+2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54255" y="4725144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74" name="Picture 6" descr="G:\13.06.25 U2OS siMDC1-PID3.mdb\사진\U2OSsiMDC1-P-ID3-30min-crop10_c2.jpg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80528" y="2744276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75" name="Picture 7" descr="G:\13.06.25 U2OS siMDC1-PID3.mdb\사진\U2OSsiMDC1-P-ID3-30min-crop1_c1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20939" y="817879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76" name="Picture 8" descr="G:\13.06.25 U2OS siMDC1-PID3.mdb\사진\U2OSsiMDC1-P-ID3-30min-crop1_c1+2.jpg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91880" y="4740219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77" name="Picture 9" descr="G:\13.06.25 U2OS siMDC1-PID3.mdb\사진\U2OSsiMDC1-P-ID3-30min-crop1_c2.jpg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94730" y="2744276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78" name="Picture 10" descr="G:\13.06.25 U2OS siMDC1-PID3.mdb\사진\U2OSsiMDC1-P-ID3-30min-crop2_c1.jpg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64088" y="4768216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80" name="Picture 12" descr="G:\13.06.25 U2OS siMDC1-PID3.mdb\사진\U2OSsiMDC1-P-ID3-30min-crop2_c2.jpg"/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64088" y="2744276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82" name="Picture 14" descr="G:\13.06.25 U2OS siMDC1-PID3.mdb\사진\U2OSsiMDC1-P-ID3-30min-crop3_c1+2.jpg"/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50370" y="4743907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83" name="Picture 15" descr="G:\13.06.25 U2OS siMDC1-PID3.mdb\사진\U2OSsiMDC1-P-ID3-30min-crop3_c2.jpg"/>
              <p:cNvPicPr>
                <a:picLocks noChangeAspect="1" noChangeArrowheads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36104" y="2744276"/>
                <a:ext cx="180000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7184" name="Picture 16" descr="G:\13.06.25 U2OS siMDC1-PID3.mdb\사진\U2OSsiMDC1-P-ID3-30min-crop4_c1.jpg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08504" y="748698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7" name="TextBox 16"/>
          <p:cNvSpPr txBox="1"/>
          <p:nvPr/>
        </p:nvSpPr>
        <p:spPr>
          <a:xfrm>
            <a:off x="486790" y="332656"/>
            <a:ext cx="22413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 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20min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187596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G:\13.06.25 U2OS siMDC1-PID3.mdb\사진\U2OSsiMDC1-P-ID3-1hr-crop2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03555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G:\13.06.25 U2OS siMDC1-PID3.mdb\사진\U2OSsiMDC1-P-ID3-1hr-crop3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40606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6" name="Picture 4" descr="G:\13.06.25 U2OS siMDC1-PID3.mdb\사진\U2OSsiMDC1-P-ID3-1hr-crop3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470822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7" name="Picture 5" descr="G:\13.06.25 U2OS siMDC1-PID3.mdb\사진\U2OSsiMDC1-P-ID3-1hr-crop3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8" name="Picture 6" descr="G:\13.06.25 U2OS siMDC1-PID3.mdb\사진\U2OSsiMDC1-P-ID3-1hr-crop4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1800" y="40606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9" name="Picture 7" descr="G:\13.06.25 U2OS siMDC1-PID3.mdb\사진\U2OSsiMDC1-P-ID3-1hr-crop4_c1+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1800" y="471583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0" name="Picture 8" descr="G:\13.06.25 U2OS siMDC1-PID3.mdb\사진\U2OSsiMDC1-P-ID3-1hr-crop4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1800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1" name="Picture 9" descr="G:\13.06.25 U2OS siMDC1-PID3.mdb\사진\U2OSsiMDC1-P-ID3-1hr-crop1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032" y="41285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2" name="Picture 10" descr="G:\13.06.25 U2OS siMDC1-PID3.mdb\사진\U2OSsiMDC1-P-ID3-1hr-crop1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52532" y="471583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3" name="Picture 11" descr="G:\13.06.25 U2OS siMDC1-PID3.mdb\사진\U2OSsiMDC1-P-ID3-1hr-crop1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032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4" name="Picture 12" descr="G:\13.06.25 U2OS siMDC1-PID3.mdb\사진\U2OSsiMDC1-P-ID3-1hr-crop2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40466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5" name="Picture 13" descr="G:\13.06.25 U2OS siMDC1-PID3.mdb\사진\U2OSsiMDC1-P-ID3-1hr-crop2_c1+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520443" y="660072"/>
            <a:ext cx="22413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40min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187596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G:\13.06.25 U2OS siMDC1-PID3.mdb\사진\U2OSsiMDC1-P-ID3-3hr-crop2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14558" y="25615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9" name="Picture 3" descr="G:\13.06.25 U2OS siMDC1-PID3.mdb\사진\U2OSsiMDC1-P-ID3-3hr-crop3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854" y="46541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0" name="Picture 4" descr="G:\13.06.25 U2OS siMDC1-PID3.mdb\사진\U2OSsiMDC1-P-ID3-3hr-crop3_c1+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854" y="465253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1" name="Picture 5" descr="G:\13.06.25 U2OS siMDC1-PID3.mdb\사진\U2OSsiMDC1-P-ID3-3hr-crop3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854" y="255364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2" name="Picture 6" descr="G:\13.06.25 U2OS siMDC1-PID3.mdb\사진\U2OSsiMDC1-P-ID3-3hr-crop4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6170" y="46541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3" name="Picture 7" descr="G:\13.06.25 U2OS siMDC1-PID3.mdb\사진\U2OSsiMDC1-P-ID3-3hr-crop4_c1+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6086" y="465253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4" name="Picture 8" descr="G:\13.06.25 U2OS siMDC1-PID3.mdb\사진\U2OSsiMDC1-P-ID3-3hr-crop4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6086" y="25615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5" name="Picture 9" descr="G:\13.06.25 U2OS siMDC1-PID3.mdb\사진\U2OSsiMDC1-P-ID3-3hr-crop1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6326" y="46541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6" name="Picture 10" descr="G:\13.06.25 U2OS siMDC1-PID3.mdb\사진\U2OSsiMDC1-P-ID3-3hr-crop1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6326" y="464981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7" name="Picture 11" descr="G:\13.06.25 U2OS siMDC1-PID3.mdb\사진\U2OSsiMDC1-P-ID3-3hr-crop1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6326" y="25615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8" name="Picture 12" descr="G:\13.06.25 U2OS siMDC1-PID3.mdb\사진\U2OSsiMDC1-P-ID3-3hr-crop2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14558" y="46541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9" name="Picture 13" descr="G:\13.06.25 U2OS siMDC1-PID3.mdb\사진\U2OSsiMDC1-P-ID3-3hr-crop2_c1+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465313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530481" y="660072"/>
            <a:ext cx="22413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1hr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2235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G:\13.06.25 U2OS siMDC1-PID3.mdb\U2OSsiCTL-P-ID3-30min-3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1660" y="25286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G:\13.06.25 U2OS siMDC1-PID3.mdb\U2OSsiCTL-P-ID3-30min-4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099" y="40466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G:\13.06.25 U2OS siMDC1-PID3.mdb\U2OSsiCTL-P-ID3-30min-4_c1+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6016" y="468892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G:\13.06.25 U2OS siMDC1-PID3.mdb\U2OSsiCTL-P-ID3-30min-4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099" y="25286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G:\13.06.25 U2OS siMDC1-PID3.mdb\U2OSsiCTL-P-ID3-30min-1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4798" y="40466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G:\13.06.25 U2OS siMDC1-PID3.mdb\U2OSsiCTL-P-ID3-30min-1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4248" y="468892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G:\13.06.25 U2OS siMDC1-PID3.mdb\U2OSsiCTL-P-ID3-30min-1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4248" y="25286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G:\13.06.25 U2OS siMDC1-PID3.mdb\U2OSsiCTL-P-ID3-30min-2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480" y="40466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G:\13.06.25 U2OS siMDC1-PID3.mdb\U2OSsiCTL-P-ID3-30min-2_c1+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480" y="468590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9" name="Picture 11" descr="G:\13.06.25 U2OS siMDC1-PID3.mdb\U2OSsiCTL-P-ID3-30min-2_c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480" y="25286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0" name="Picture 12" descr="G:\13.06.25 U2OS siMDC1-PID3.mdb\U2OSsiCTL-P-ID3-30min-3_c1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6496" y="40466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1" name="Picture 13" descr="G:\13.06.25 U2OS siMDC1-PID3.mdb\U2OSsiCTL-P-ID3-30min-3_c1+2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6496" y="468892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708452" y="476672"/>
            <a:ext cx="196239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 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20min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3278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G:\13.06.25 U2OS siMDC1-PID3.mdb\사진\U2OSsiMDC1-P-ID3-6hr-crop3_c1+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02431" y="4745241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3" name="Picture 3" descr="G:\13.06.25 U2OS siMDC1-PID3.mdb\사진\U2OSsiMDC1-P-ID3-6hr-crop3_c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8504" y="259565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4" name="Picture 4" descr="G:\13.06.25 U2OS siMDC1-PID3.mdb\사진\U2OSsiMDC1-P-ID3-6hr-crop4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5621" y="50742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5" name="Picture 5" descr="G:\13.06.25 U2OS siMDC1-PID3.mdb\사진\U2OSsiMDC1-P-ID3-6hr-crop4_c1+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5621" y="476136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6" name="Picture 6" descr="G:\13.06.25 U2OS siMDC1-PID3.mdb\사진\U2OSsiMDC1-P-ID3-6hr-crop4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5621" y="259565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7" name="Picture 7" descr="G:\13.06.25 U2OS siMDC1-PID3.mdb\사진\U2OSsiMDC1-P-ID3-6hr-crop1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5967" y="50742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8" name="Picture 8" descr="G:\13.06.25 U2OS siMDC1-PID3.mdb\사진\U2OSsiMDC1-P-ID3-6hr-crop1_c1+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5967" y="4745241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49" name="Picture 9" descr="G:\13.06.25 U2OS siMDC1-PID3.mdb\사진\U2OSsiMDC1-P-ID3-6hr-crop1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5967" y="259565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0" name="Picture 10" descr="G:\13.06.25 U2OS siMDC1-PID3.mdb\사진\U2OSsiMDC1-P-ID3-6hr-crop2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4199" y="50742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1" name="Picture 11" descr="G:\13.06.25 U2OS siMDC1-PID3.mdb\사진\U2OSsiMDC1-P-ID3-6hr-crop2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4199" y="475589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2" name="Picture 12" descr="G:\13.06.25 U2OS siMDC1-PID3.mdb\사진\U2OSsiMDC1-P-ID3-6hr-crop2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4199" y="259565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3" name="Picture 13" descr="G:\13.06.25 U2OS siMDC1-PID3.mdb\사진\U2OSsiMDC1-P-ID3-6hr-crop3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8504" y="50742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520443" y="660072"/>
            <a:ext cx="22413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3hr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054704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72723" y="679438"/>
            <a:ext cx="157947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</a:t>
            </a:r>
            <a:r>
              <a:rPr lang="en-US" altLang="ko-KR" sz="1662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19" descr="C:\Users\chosun\Desktop\progress report\17.02.28 progress report\17.02.28 U2OS P-ID3 early time\U2OS10Gy-UT-P-ID3-crop6-Image Export-31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6212" y="134076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20" descr="C:\Users\chosun\Desktop\progress report\17.02.28 progress report\17.02.28 U2OS P-ID3 early time\U2OS10Gy-UT-P-ID3-crop6-Image Export-31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2613" y="413261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1" descr="C:\Users\chosun\Desktop\progress report\17.02.28 progress report\17.02.28 U2OS P-ID3 early time\U2OS10Gy-UT-P-ID3-crop6-Image Export-31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7948" y="273661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077544" y="679438"/>
            <a:ext cx="468398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10" descr="C:\Users\chosun\Desktop\progress report\17.02.28 progress report\17.02.28 U2OS P-ID3 early time\U2OS10Gy-UT-P-ID3-crop3-Image Export-28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768" y="134076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11" descr="C:\Users\chosun\Desktop\progress report\17.02.28 progress report\17.02.28 U2OS P-ID3 early time\U2OS10Gy-UT-P-ID3-crop3-Image Export-28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9474" y="414834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12" descr="C:\Users\chosun\Desktop\progress report\17.02.28 progress report\17.02.28 U2OS P-ID3 early time\U2OS10Gy-UT-P-ID3-crop3-Image Export-28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9474" y="273676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843082" y="1155461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  <p:sp>
        <p:nvSpPr>
          <p:cNvPr id="12" name="TextBox 11"/>
          <p:cNvSpPr txBox="1"/>
          <p:nvPr/>
        </p:nvSpPr>
        <p:spPr>
          <a:xfrm>
            <a:off x="4317946" y="627433"/>
            <a:ext cx="157947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</a:t>
            </a:r>
            <a:r>
              <a:rPr lang="en-US" altLang="ko-KR" sz="1662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2" descr="C:\Users\chosun\Desktop\progress report\17.02.28 progress report\17.02.28 U2OS P-ID3 early time\U2OS10Gy-0min-P-ID3-crop6-Image Export-07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943" y="272892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1" descr="C:\Users\chosun\Desktop\progress report\17.02.28 progress report\17.02.28 U2OS P-ID3 early time\U2OS10Gy-0min-P-ID3-crop6-Image Export-07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2602" y="132071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22" descr="C:\Users\chosun\Desktop\progress report\17.02.28 progress report\17.02.28 U2OS P-ID3 early time\U2OS10Gy-0min-P-ID3-crop6-Image Export-07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20389" y="411241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7442696" y="541905"/>
            <a:ext cx="42511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5" descr="C:\Users\chosun\Desktop\progress report\17.02.28 progress report\17.02.28 U2OS P-ID3 early time\U2OS10Gy-0min-P-ID3-crop4-Image Export-05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3209" y="132071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6" descr="C:\Users\chosun\Desktop\progress report\17.02.28 progress report\17.02.28 U2OS P-ID3 early time\U2OS10Gy-0min-P-ID3-crop4-Image Export-05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3209" y="411599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17" descr="C:\Users\chosun\Desktop\progress report\17.02.28 progress report\17.02.28 U2OS P-ID3 early time\U2OS10Gy-0min-P-ID3-crop4-Image Export-05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3209" y="271862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18" descr="C:\Users\chosun\Desktop\progress report\17.02.28 progress report\17.02.28 U2OS P-ID3 early time\U2OS10Gy-0min-P-ID3-crop5-Image Export-06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1795" y="132071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19" descr="C:\Users\chosun\Desktop\progress report\17.02.28 progress report\17.02.28 U2OS P-ID3 early time\U2OS10Gy-0min-P-ID3-crop5-Image Export-06_c1+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6697" y="411241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0" descr="C:\Users\chosun\Desktop\progress report\17.02.28 progress report\17.02.28 U2OS P-ID3 early time\U2OS10Gy-0min-P-ID3-crop5-Image Export-06_c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0575" y="271656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직사각형 22"/>
          <p:cNvSpPr/>
          <p:nvPr/>
        </p:nvSpPr>
        <p:spPr>
          <a:xfrm>
            <a:off x="5707144" y="1173202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408433546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237019" y="535422"/>
            <a:ext cx="157947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</a:t>
            </a:r>
            <a:r>
              <a:rPr lang="en-US" altLang="ko-KR" sz="1662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22" descr="C:\Users\chosun\Desktop\progress report\17.02.28 progress report\17.02.28 U2OS P-ID3 early time\U2OS10Gy-10min-P-ID3-crop6-Image Export-15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1596" y="1452019"/>
            <a:ext cx="1329231" cy="1329231"/>
          </a:xfrm>
          <a:prstGeom prst="rect">
            <a:avLst/>
          </a:prstGeom>
          <a:noFill/>
          <a:ln>
            <a:solidFill>
              <a:srgbClr val="FFFF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23" descr="C:\Users\chosun\Desktop\progress report\17.02.28 progress report\17.02.28 U2OS P-ID3 early time\U2OS10Gy-10min-P-ID3-crop6-Image Export-15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1770" y="4285053"/>
            <a:ext cx="1329231" cy="1329231"/>
          </a:xfrm>
          <a:prstGeom prst="rect">
            <a:avLst/>
          </a:prstGeom>
          <a:noFill/>
          <a:ln>
            <a:solidFill>
              <a:srgbClr val="FFFF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4" descr="C:\Users\chosun\Desktop\progress report\17.02.28 progress report\17.02.28 U2OS P-ID3 early time\U2OS10Gy-10min-P-ID3-crop6-Image Export-15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9907" y="2847867"/>
            <a:ext cx="1329231" cy="1329231"/>
          </a:xfrm>
          <a:prstGeom prst="rect">
            <a:avLst/>
          </a:prstGeom>
          <a:noFill/>
          <a:ln>
            <a:solidFill>
              <a:srgbClr val="FFFF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5237109" y="476672"/>
            <a:ext cx="1098378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10 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16" descr="C:\Users\chosun\Desktop\progress report\17.02.28 progress report\17.02.28 U2OS P-ID3 early time\U2OS10Gy-10min-P-ID3-crop4-Image Export-13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6415" y="145201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17" descr="C:\Users\chosun\Desktop\progress report\17.02.28 progress report\17.02.28 U2OS P-ID3 early time\U2OS10Gy-10min-P-ID3-crop4-Image Export-13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0072" y="428505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18" descr="C:\Users\chosun\Desktop\progress report\17.02.28 progress report\17.02.28 U2OS P-ID3 early time\U2OS10Gy-10min-P-ID3-crop4-Image Export-13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0072" y="285293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9" descr="C:\Users\chosun\Desktop\progress report\17.02.28 progress report\17.02.28 U2OS P-ID3 early time\U2OS10Gy-10min-P-ID3-crop5-Image Export-14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0730" y="145201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20" descr="C:\Users\chosun\Desktop\progress report\17.02.28 progress report\17.02.28 U2OS P-ID3 early time\U2OS10Gy-10min-P-ID3-crop5-Image Export-14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9584" y="428505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21" descr="C:\Users\chosun\Desktop\progress report\17.02.28 progress report\17.02.28 U2OS P-ID3 early time\U2OS10Gy-10min-P-ID3-crop5-Image Export-14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0730" y="285293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7" descr="C:\Users\chosun\Desktop\progress report\17.02.28 progress report\17.02.28 U2OS P-ID3 early time\U2OS10Gy-10min-P-ID3-crop1-Image Export-10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0342" y="145502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8" descr="C:\Users\chosun\Desktop\progress report\17.02.28 progress report\17.02.28 U2OS P-ID3 early time\U2OS10Gy-10min-P-ID3-crop1-Image Export-10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0342" y="428505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" name="Picture 9" descr="C:\Users\chosun\Desktop\progress report\17.02.28 progress report\17.02.28 U2OS P-ID3 early time\U2OS10Gy-10min-P-ID3-crop1-Image Export-10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0342" y="285293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직사각형 21"/>
          <p:cNvSpPr/>
          <p:nvPr/>
        </p:nvSpPr>
        <p:spPr>
          <a:xfrm>
            <a:off x="2275546" y="1225529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241897726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237019" y="535422"/>
            <a:ext cx="157947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</a:t>
            </a:r>
            <a:r>
              <a:rPr lang="en-US" altLang="ko-KR" sz="1662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23" descr="C:\Users\chosun\Desktop\progress report\17.02.28 progress report\17.02.28 U2OS P-ID3 early time\U2OS10Gy-20min-P-ID3-crop6-Image Export-23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2212" y="132854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24" descr="C:\Users\chosun\Desktop\progress report\17.02.28 progress report\17.02.28 U2OS P-ID3 early time\U2OS10Gy-20min-P-ID3-crop6-Image Export-23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2212" y="410135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25" descr="C:\Users\chosun\Desktop\progress report\17.02.28 progress report\17.02.28 U2OS P-ID3 early time\U2OS10Gy-20min-P-ID3-crop6-Image Export-23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2212" y="272439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5292080" y="535421"/>
            <a:ext cx="112082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20 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8" descr="C:\Users\chosun\Desktop\progress report\17.02.28 progress report\17.02.28 U2OS P-ID3 early time\U2OS10Gy-20min-P-ID3-crop1-Image Export-18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4503" y="132854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9" descr="C:\Users\chosun\Desktop\progress report\17.02.28 progress report\17.02.28 U2OS P-ID3 early time\U2OS10Gy-20min-P-ID3-crop1-Image Export-18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4503" y="410135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10" descr="C:\Users\chosun\Desktop\progress report\17.02.28 progress report\17.02.28 U2OS P-ID3 early time\U2OS10Gy-20min-P-ID3-crop1-Image Export-18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4503" y="272439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4" descr="C:\Users\chosun\Desktop\progress report\17.02.28 progress report\17.02.28 U2OS P-ID3 early time\U2OS10Gy-20min-P-ID3-crop3-Image Export-20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4415" y="132854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15" descr="C:\Users\chosun\Desktop\progress report\17.02.28 progress report\17.02.28 U2OS P-ID3 early time\U2OS10Gy-20min-P-ID3-crop3-Image Export-20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2366" y="410135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16" descr="C:\Users\chosun\Desktop\progress report\17.02.28 progress report\17.02.28 U2OS P-ID3 early time\U2OS10Gy-20min-P-ID3-crop3-Image Export-20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46833" y="272439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17" descr="C:\Users\chosun\Desktop\progress report\17.02.28 progress report\17.02.28 U2OS P-ID3 early time\U2OS10Gy-20min-P-ID3-crop4-Image Export-21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4224" y="1328549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18" descr="C:\Users\chosun\Desktop\progress report\17.02.28 progress report\17.02.28 U2OS P-ID3 early time\U2OS10Gy-20min-P-ID3-crop4-Image Export-21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1296" y="410135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19" descr="C:\Users\chosun\Desktop\progress report\17.02.28 progress report\17.02.28 U2OS P-ID3 early time\U2OS10Gy-20min-P-ID3-crop4-Image Export-21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1296" y="272439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직사각형 17"/>
          <p:cNvSpPr/>
          <p:nvPr/>
        </p:nvSpPr>
        <p:spPr>
          <a:xfrm>
            <a:off x="6076065" y="1187570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319457477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174544" y="766848"/>
            <a:ext cx="157947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</a:t>
            </a:r>
            <a:r>
              <a:rPr lang="en-US" altLang="ko-KR" sz="1662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10" descr="C:\Users\chosun\Desktop\progress report\17.02.15 progress report\siID3-MDC1,P-ID3\U2OSsiCTL-2Gy-30min_P-ID3-crop3-Image Export-23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6015" y="177281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1" descr="C:\Users\chosun\Desktop\progress report\17.02.15 progress report\siID3-MDC1,P-ID3\U2OSsiCTL-2Gy-30min_P-ID3-crop3-Image Export-23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279" y="456797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2" descr="C:\Users\chosun\Desktop\progress report\17.02.15 progress report\siID3-MDC1,P-ID3\U2OSsiCTL-2Gy-30min_P-ID3-crop3-Image Export-23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6015" y="315637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3131840" y="766848"/>
            <a:ext cx="112082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40 </a:t>
            </a:r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2" descr="C:\Users\chosun\Desktop\progress report\17.02.28 progress report\17.02.28 U2OS P-ID3 early time\U2OSP-ID3-10Gy-40min-crop5-Image Export-39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5469" y="315637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24" descr="C:\Users\chosun\Desktop\progress report\17.02.28 progress report\17.02.28 U2OS P-ID3 early time\U2OSP-ID3-10Gy-40min-crop4-Image Export-38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9872" y="177281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25" descr="C:\Users\chosun\Desktop\progress report\17.02.28 progress report\17.02.28 U2OS P-ID3 early time\U2OSP-ID3-10Gy-40min-crop4-Image Export-38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9872" y="456797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26" descr="C:\Users\chosun\Desktop\progress report\17.02.28 progress report\17.02.28 U2OS P-ID3 early time\U2OSP-ID3-10Gy-40min-crop4-Image Export-38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9872" y="315637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27" descr="C:\Users\chosun\Desktop\progress report\17.02.28 progress report\17.02.28 U2OS P-ID3 early time\U2OSP-ID3-10Gy-40min-crop5-Image Export-39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4172" y="177281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" name="Picture 28" descr="C:\Users\chosun\Desktop\progress report\17.02.28 progress report\17.02.28 U2OS P-ID3 early time\U2OSP-ID3-10Gy-40min-crop5-Image Export-39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4320" y="4567972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8" name="직사각형 57"/>
          <p:cNvSpPr/>
          <p:nvPr/>
        </p:nvSpPr>
        <p:spPr>
          <a:xfrm>
            <a:off x="491899" y="1651718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  <p:sp>
        <p:nvSpPr>
          <p:cNvPr id="23" name="TextBox 22"/>
          <p:cNvSpPr txBox="1"/>
          <p:nvPr/>
        </p:nvSpPr>
        <p:spPr>
          <a:xfrm>
            <a:off x="5533619" y="815255"/>
            <a:ext cx="157947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</a:t>
            </a:r>
            <a:r>
              <a:rPr lang="en-US" altLang="ko-KR" sz="1662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0" descr="C:\Users\chosun\Desktop\progress report\17.02.28 progress report\17.02.28 U2OS P-ID3 early time\U2OSP-ID3-10Gy-60min-crop12-Image Export-48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2227" y="171896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21" descr="C:\Users\chosun\Desktop\progress report\17.02.28 progress report\17.02.28 U2OS P-ID3 early time\U2OSP-ID3-10Gy-60min-crop12-Image Export-48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2227" y="447603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22" descr="C:\Users\chosun\Desktop\progress report\17.02.28 progress report\17.02.28 U2OS P-ID3 early time\U2OSP-ID3-10Gy-60min-crop12-Image Export-48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2227" y="310630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7395397" y="815256"/>
            <a:ext cx="112082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60 </a:t>
            </a:r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Picture 11" descr="C:\Users\chosun\Desktop\progress report\17.02.28 progress report\17.02.28 U2OS P-ID3 early time\U2OSP-ID3-10Gy-60min-crop4-Image Export-45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7185" y="171896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12" descr="C:\Users\chosun\Desktop\progress report\17.02.28 progress report\17.02.28 U2OS P-ID3 early time\U2OSP-ID3-10Gy-60min-crop4-Image Export-45_c1+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7185" y="447603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13" descr="C:\Users\chosun\Desktop\progress report\17.02.28 progress report\17.02.28 U2OS P-ID3 early time\U2OSP-ID3-10Gy-60min-crop4-Image Export-45_c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7185" y="310630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0" name="직사각형 49"/>
          <p:cNvSpPr/>
          <p:nvPr/>
        </p:nvSpPr>
        <p:spPr>
          <a:xfrm>
            <a:off x="5438206" y="1550585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135581135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275856" y="480089"/>
            <a:ext cx="157947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</a:t>
            </a:r>
            <a:r>
              <a:rPr lang="en-US" altLang="ko-KR" sz="1662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" descr="C:\Users\chosun\Desktop\progress report\17.02.28 progress report\17.02.28 U2OS P-ID3 early time\U2OSP-ID3-10Gy-180min-crop6-Image Export-57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9934" y="292494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7" descr="C:\Users\chosun\Desktop\progress report\17.02.28 progress report\17.02.28 U2OS P-ID3 early time\U2OSP-ID3-10Gy-180min-crop6-Image Export-57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6995" y="15302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28" descr="C:\Users\chosun\Desktop\progress report\17.02.28 progress report\17.02.28 U2OS P-ID3 early time\U2OSP-ID3-10Gy-180min-crop6-Image Export-57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6995" y="429549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5161983" y="480089"/>
            <a:ext cx="123783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180 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Picture 12" descr="C:\Users\chosun\Desktop\progress report\17.02.28 progress report\17.02.28 U2OS P-ID3 early time\U2OSP-ID3-10Gy-180min-crop1-Image Export-52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1184" y="15302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13" descr="C:\Users\chosun\Desktop\progress report\17.02.28 progress report\17.02.28 U2OS P-ID3 early time\U2OSP-ID3-10Gy-180min-crop1-Image Export-52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1184" y="429549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14" descr="C:\Users\chosun\Desktop\progress report\17.02.28 progress report\17.02.28 U2OS P-ID3 early time\U2OSP-ID3-10Gy-180min-crop1-Image Export-52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1184" y="292494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2" descr="C:\Users\chosun\Desktop\progress report\17.02.15 progress report\siID3-MDC1,P-ID3\U2OSsiCTL-2Gy-30min_MDC1-crop2-Image Export-16_c1+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8662" y="429549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3" name="Picture 3" descr="C:\Users\chosun\Desktop\progress report\17.02.15 progress report\siID3-MDC1,P-ID3\U2OSsiCTL-2Gy-30min_MDC1-crop2-Image Export-16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1903" y="292494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4" descr="C:\Users\chosun\Desktop\progress report\17.02.15 progress report\siID3-MDC1,P-ID3\U2OSsiCTL-2Gy-30min_MDC1-crop3-Image Export-17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6056" y="15302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5" descr="C:\Users\chosun\Desktop\progress report\17.02.15 progress report\siID3-MDC1,P-ID3\U2OSsiCTL-2Gy-30min_MDC1-crop3-Image Export-17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6056" y="429549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6" descr="C:\Users\chosun\Desktop\progress report\17.02.15 progress report\siID3-MDC1,P-ID3\U2OSsiCTL-2Gy-30min_MDC1-crop3-Image Export-17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6056" y="2924944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7" name="Picture 19" descr="C:\Users\chosun\Desktop\progress report\17.02.15 progress report\siID3-MDC1,P-ID3\U2OSsiCTL-2Gy-30min_MDC1-crop2-Image Export-16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8662" y="15302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직사각형 24"/>
          <p:cNvSpPr/>
          <p:nvPr/>
        </p:nvSpPr>
        <p:spPr>
          <a:xfrm>
            <a:off x="2131067" y="1369223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285521160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3" descr="C:\Users\chosun\Desktop\progress report\17.02.28 progress report\17.02.28 U2OS P-ID3 early time\U2OS10Gy-UT-P-ID3-crop4-Image Export-29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1285" y="170080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14" descr="C:\Users\chosun\Desktop\progress report\17.02.28 progress report\17.02.28 U2OS P-ID3 early time\U2OS10Gy-UT-P-ID3-crop4-Image Export-29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1285" y="447759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15" descr="C:\Users\chosun\Desktop\progress report\17.02.28 progress report\17.02.28 U2OS P-ID3 early time\U2OS10Gy-UT-P-ID3-crop4-Image Export-29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1285" y="308189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291978" y="1063720"/>
            <a:ext cx="152317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siMDC1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813907" y="1063720"/>
            <a:ext cx="468398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8" descr="C:\Users\chosun\Desktop\progress report\17.06.22 U2OS P-ID3,rH2ax.mdb\UT-Rh2AXP-ID3-3-Image Export-04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7784" y="1700808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11" descr="C:\Users\chosun\Desktop\progress report\17.06.22 U2OS P-ID3,rH2ax.mdb\UT-Rh2AXP-ID3-3-Image Export-04_c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7784" y="308189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8" descr="C:\Users\chosun\Desktop\progress report\17.06.22 U2OS P-ID3,rH2ax.mdb\UT-Rh2AXP-ID3-3-Image Export-04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7784" y="447759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직사각형 13"/>
          <p:cNvSpPr/>
          <p:nvPr/>
        </p:nvSpPr>
        <p:spPr>
          <a:xfrm>
            <a:off x="693535" y="1640472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  <p:sp>
        <p:nvSpPr>
          <p:cNvPr id="15" name="TextBox 14"/>
          <p:cNvSpPr txBox="1"/>
          <p:nvPr/>
        </p:nvSpPr>
        <p:spPr>
          <a:xfrm>
            <a:off x="5599818" y="903610"/>
            <a:ext cx="152317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siMDC1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9" descr="C:\Users\chosun\Desktop\progress report\17.02.28 progress report\17.02.28 U2OS P-ID3 early time\U2OS10Gy-0min-P-ID3-crop2-Image Export-03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3550" y="1722345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0" descr="C:\Users\chosun\Desktop\progress report\17.02.28 progress report\17.02.28 U2OS P-ID3 early time\U2OS10Gy-0min-P-ID3-crop2-Image Export-03_c1+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5425" y="447603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1" descr="C:\Users\chosun\Desktop\progress report\17.02.28 progress report\17.02.28 U2OS P-ID3 early time\U2OS10Gy-0min-P-ID3-crop2-Image Export-03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5425" y="309779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7364101" y="903610"/>
            <a:ext cx="70724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0 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59" descr="C:\Users\chosun\Desktop\progress report\17.06.22 U2OS siMDC1-P-ID3\U2OSsiMDC1-P-ID3-crop19-Image Export-08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2188" y="172234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60" descr="C:\Users\chosun\Desktop\progress report\17.06.22 U2OS siMDC1-P-ID3\U2OSsiMDC1-P-ID3-crop19-Image Export-08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2188" y="4476033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61" descr="C:\Users\chosun\Desktop\progress report\17.06.22 U2OS siMDC1-P-ID3\U2OSsiMDC1-P-ID3-crop19-Image Export-08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2188" y="309779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62" descr="C:\Users\chosun\Desktop\progress report\17.06.22 U2OS siMDC1-P-ID3\U2OSsiMDC1-P-ID3-crop20-Image Export-09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9233" y="172234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63" descr="C:\Users\chosun\Desktop\progress report\17.06.22 U2OS siMDC1-P-ID3\U2OSsiMDC1-P-ID3-crop20-Image Export-09_c1+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9233" y="4476033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64" descr="C:\Users\chosun\Desktop\progress report\17.06.22 U2OS siMDC1-P-ID3\U2OSsiMDC1-P-ID3-crop20-Image Export-09_c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9233" y="309779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직사각형 25"/>
          <p:cNvSpPr/>
          <p:nvPr/>
        </p:nvSpPr>
        <p:spPr>
          <a:xfrm>
            <a:off x="4530305" y="1542070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117558511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237019" y="535422"/>
            <a:ext cx="152317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siMDC1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 descr="C:\Users\chosun\Desktop\progress report\17.06.22 U2OS siMDC1-P-ID3\U2OSsiMDC1-P-ID3-crop7-Image Export-20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8110" y="1591840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24" descr="C:\Users\chosun\Desktop\progress report\17.06.22 U2OS siMDC1-P-ID3\U2OSsiMDC1-P-ID3-crop7-Image Export-20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8111" y="4344140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25" descr="C:\Users\chosun\Desktop\progress report\17.06.22 U2OS siMDC1-P-ID3\U2OSsiMDC1-P-ID3-crop7-Image Export-20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8111" y="295110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5103840" y="535422"/>
            <a:ext cx="112082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10 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56" descr="C:\Users\chosun\Desktop\progress report\17.06.22 U2OS siMDC1-P-ID3\U2OSsiMDC1-P-ID3-crop18-Image Export-07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3102" y="1591840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57" descr="C:\Users\chosun\Desktop\progress report\17.06.22 U2OS siMDC1-P-ID3\U2OSsiMDC1-P-ID3-crop18-Image Export-07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3102" y="4344140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58" descr="C:\Users\chosun\Desktop\progress report\17.06.22 U2OS siMDC1-P-ID3\U2OSsiMDC1-P-ID3-crop18-Image Export-07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77593" y="295110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50" descr="C:\Users\chosun\Desktop\progress report\17.06.22 U2OS siMDC1-P-ID3\U2OSsiMDC1-P-ID3-crop16-Image Export-05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3938" y="1591840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51" descr="C:\Users\chosun\Desktop\progress report\17.06.22 U2OS siMDC1-P-ID3\U2OSsiMDC1-P-ID3-crop16-Image Export-05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8718" y="4344140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52" descr="C:\Users\chosun\Desktop\progress report\17.06.22 U2OS siMDC1-P-ID3\U2OSsiMDC1-P-ID3-crop16-Image Export-05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8718" y="295110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14" descr="C:\Users\chosun\Desktop\progress report\17.06.22 U2OS siMDC1-P-ID3\U2OSsiMDC1-P-ID3-5-Image Export-17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1115" y="1591840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15" descr="C:\Users\chosun\Desktop\progress report\17.06.22 U2OS siMDC1-P-ID3\U2OSsiMDC1-P-ID3-5-Image Export-17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2205" y="4344140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16" descr="C:\Users\chosun\Desktop\progress report\17.06.22 U2OS siMDC1-P-ID3\U2OSsiMDC1-P-ID3-5-Image Export-17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1116" y="295110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직사각형 15"/>
          <p:cNvSpPr/>
          <p:nvPr/>
        </p:nvSpPr>
        <p:spPr>
          <a:xfrm>
            <a:off x="1859626" y="1470913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70861424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237019" y="535422"/>
            <a:ext cx="152317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siMDC1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35" descr="C:\Users\chosun\Desktop\progress report\17.06.22 U2OS siMDC1-P-ID3\U2OSsiMDC1-P-ID3-crop11-Image Export-24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2492" y="140602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36" descr="C:\Users\chosun\Desktop\progress report\17.06.22 U2OS siMDC1-P-ID3\U2OSsiMDC1-P-ID3-crop11-Image Export-24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2493" y="414491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37" descr="C:\Users\chosun\Desktop\progress report\17.06.22 U2OS siMDC1-P-ID3\U2OSsiMDC1-P-ID3-crop11-Image Export-24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2493" y="277267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5148064" y="535422"/>
            <a:ext cx="112082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20 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26" descr="C:\Users\chosun\Desktop\progress report\17.06.22 U2OS siMDC1-P-ID3\U2OSsiMDC1-P-ID3-crop8-Image Export-21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2276" y="140602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27" descr="C:\Users\chosun\Desktop\progress report\17.06.22 U2OS siMDC1-P-ID3\U2OSsiMDC1-P-ID3-crop8-Image Export-21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47636" y="414491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28" descr="C:\Users\chosun\Desktop\progress report\17.06.22 U2OS siMDC1-P-ID3\U2OSsiMDC1-P-ID3-crop8-Image Export-21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4846" y="277267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29" descr="C:\Users\chosun\Desktop\progress report\17.06.22 U2OS siMDC1-P-ID3\U2OSsiMDC1-P-ID3-crop9-Image Export-22_c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9591" y="140602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30" descr="C:\Users\chosun\Desktop\progress report\17.06.22 U2OS siMDC1-P-ID3\U2OSsiMDC1-P-ID3-crop9-Image Export-22_c1+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9592" y="414491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31" descr="C:\Users\chosun\Desktop\progress report\17.06.22 U2OS siMDC1-P-ID3\U2OSsiMDC1-P-ID3-crop9-Image Export-22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9592" y="277267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32" descr="C:\Users\chosun\Desktop\progress report\17.06.22 U2OS siMDC1-P-ID3\U2OSsiMDC1-P-ID3-crop10-Image Export-23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4337" y="140602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33" descr="C:\Users\chosun\Desktop\progress report\17.06.22 U2OS siMDC1-P-ID3\U2OSsiMDC1-P-ID3-crop10-Image Export-23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4337" y="414491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34" descr="C:\Users\chosun\Desktop\progress report\17.06.22 U2OS siMDC1-P-ID3\U2OSsiMDC1-P-ID3-crop10-Image Export-23_c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4337" y="277267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직사각형 15"/>
          <p:cNvSpPr/>
          <p:nvPr/>
        </p:nvSpPr>
        <p:spPr>
          <a:xfrm>
            <a:off x="6189247" y="1321338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345175220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237019" y="535422"/>
            <a:ext cx="152317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siMDC1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2" descr="C:\Users\chosun\Desktop\progress report\17.06.22 U2OS siMDC1-P-ID3\U2OSsiMDC1-P-ID3-Image Export-13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1679" y="134899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3" descr="C:\Users\chosun\Desktop\progress report\17.06.22 U2OS siMDC1-P-ID3\U2OSsiMDC1-P-ID3-Image Export-13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1679" y="411359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4" descr="C:\Users\chosun\Desktop\progress report\17.06.22 U2OS siMDC1-P-ID3\U2OSsiMDC1-P-ID3-Image Export-13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1679" y="2729356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5004048" y="547426"/>
            <a:ext cx="112082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40 </a:t>
            </a:r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8" descr="C:\Users\chosun\Desktop\progress report\17.06.22 U2OS siMDC1-P-ID3\U2OSsiMDC1-P-ID3-3-Image Export-15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9113" y="134899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9" descr="C:\Users\chosun\Desktop\progress report\17.06.22 U2OS siMDC1-P-ID3\U2OSsiMDC1-P-ID3-3-Image Export-15_c1+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9113" y="411359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10" descr="C:\Users\chosun\Desktop\progress report\17.06.22 U2OS siMDC1-P-ID3\U2OSsiMDC1-P-ID3-3-Image Export-15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9113" y="2729356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11" descr="C:\Users\chosun\Desktop\progress report\17.06.22 U2OS siMDC1-P-ID3\U2OSsiMDC1-P-ID3-4-Image Export-16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6474" y="134899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12" descr="C:\Users\chosun\Desktop\progress report\17.06.22 U2OS siMDC1-P-ID3\U2OSsiMDC1-P-ID3-4-Image Export-16_c1+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6475" y="411359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13" descr="C:\Users\chosun\Desktop\progress report\17.06.22 U2OS siMDC1-P-ID3\U2OSsiMDC1-P-ID3-4-Image Export-16_c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6476" y="2729356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17" descr="C:\Users\chosun\Desktop\progress report\17.06.22 U2OS siMDC1-P-ID3\U2OSsiMDC1-P-ID3-crop5-Image Export-18_c1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1296" y="134899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18" descr="C:\Users\chosun\Desktop\progress report\17.06.22 U2OS siMDC1-P-ID3\U2OSsiMDC1-P-ID3-crop5-Image Export-18_c1+2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1296" y="4113595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19" descr="C:\Users\chosun\Desktop\progress report\17.06.22 U2OS siMDC1-P-ID3\U2OSsiMDC1-P-ID3-crop5-Image Export-18_c2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1296" y="2729356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직사각형 20"/>
          <p:cNvSpPr/>
          <p:nvPr/>
        </p:nvSpPr>
        <p:spPr>
          <a:xfrm>
            <a:off x="1968976" y="1173635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19324544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G:\13.06.25 U2OS siMDC1-PID3.mdb\U2OSsiCTL-P-ID3-1hr-3_c1+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9940" y="443711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G:\13.06.25 U2OS siMDC1-PID3.mdb\U2OSsiCTL-P-ID3-1hr-3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8264" y="233616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G:\13.06.25 U2OS siMDC1-PID3.mdb\U2OSsiCTL-P-ID3-1hr-4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25974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G:\13.06.25 U2OS siMDC1-PID3.mdb\U2OSsiCTL-P-ID3-1hr-4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443711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G:\13.06.25 U2OS siMDC1-PID3.mdb\U2OSsiCTL-P-ID3-1hr-4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2336167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9" name="Picture 7" descr="G:\13.06.25 U2OS siMDC1-PID3.mdb\U2OSsiCTL-P-ID3-1hr-1_c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6086" y="26064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 descr="G:\13.06.25 U2OS siMDC1-PID3.mdb\U2OSsiCTL-P-ID3-1hr-1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6086" y="443711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1" name="Picture 9" descr="G:\13.06.25 U2OS siMDC1-PID3.mdb\U2OSsiCTL-P-ID3-1hr-1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1800" y="23488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2" name="Picture 10" descr="G:\13.06.25 U2OS siMDC1-PID3.mdb\U2OSsiCTL-P-ID3-1hr-2_c1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032" y="26064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3" name="Picture 11" descr="G:\13.06.25 U2OS siMDC1-PID3.mdb\U2OSsiCTL-P-ID3-1hr-2_c1+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032" y="443711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 descr="G:\13.06.25 U2OS siMDC1-PID3.mdb\U2OSsiCTL-P-ID3-1hr-2_c2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032" y="23488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5" name="Picture 13" descr="G:\13.06.25 U2OS siMDC1-PID3.mdb\U2OSsiCTL-P-ID3-1hr-3_c1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9940" y="25974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371873" y="194335"/>
            <a:ext cx="196239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 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40min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32783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078777" y="404664"/>
            <a:ext cx="152317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siMDC1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38" descr="C:\Users\chosun\Desktop\progress report\17.06.22 U2OS siMDC1-P-ID3\U2OSsiMDC1-P-ID3-crop12-Image Export-01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8162" y="1134417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39" descr="C:\Users\chosun\Desktop\progress report\17.06.22 U2OS siMDC1-P-ID3\U2OSsiMDC1-P-ID3-crop12-Image Export-01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8163" y="3883209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40" descr="C:\Users\chosun\Desktop\progress report\17.06.22 U2OS siMDC1-P-ID3\U2OSsiMDC1-P-ID3-crop12-Image Export-01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8163" y="250776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4938209" y="407070"/>
            <a:ext cx="112082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60 </a:t>
            </a:r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2" descr="C:\Users\chosun\Desktop\progress report\17.02.15 progress report\siID3-MDC1,P-ID3\U2OSsiID3-2Gy-30min_P-ID3-crop4-Image Export-48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7526" y="388320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3" descr="C:\Users\chosun\Desktop\progress report\17.02.15 progress report\siID3-MDC1,P-ID3\U2OSsiID3-2Gy-30min_P-ID3-crop4-Image Export-48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7526" y="25077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10" descr="C:\Users\chosun\Desktop\progress report\17.02.15 progress report\siID3-MDC1,P-ID3\U2OSsiID3-2Gy-30min_P-ID3-crop1-Image Export-45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5382" y="113441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11" descr="C:\Users\chosun\Desktop\progress report\17.02.15 progress report\siID3-MDC1,P-ID3\U2OSsiID3-2Gy-30min_P-ID3-crop1-Image Export-45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5382" y="388320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12" descr="C:\Users\chosun\Desktop\progress report\17.02.15 progress report\siID3-MDC1,P-ID3\U2OSsiID3-2Gy-30min_P-ID3-crop1-Image Export-45_c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5382" y="25077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13" descr="C:\Users\chosun\Desktop\progress report\17.02.15 progress report\siID3-MDC1,P-ID3\U2OSsiID3-2Gy-30min_P-ID3-crop2-Image Export-46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9535" y="113441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14" descr="C:\Users\chosun\Desktop\progress report\17.02.15 progress report\siID3-MDC1,P-ID3\U2OSsiID3-2Gy-30min_P-ID3-crop2-Image Export-46_c1+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9535" y="388320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15" descr="C:\Users\chosun\Desktop\progress report\17.02.15 progress report\siID3-MDC1,P-ID3\U2OSsiID3-2Gy-30min_P-ID3-crop2-Image Export-46_c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9535" y="25077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16" descr="C:\Users\chosun\Desktop\progress report\17.02.15 progress report\siID3-MDC1,P-ID3\U2OSsiID3-2Gy-30min_P-ID3-crop3-Image Export-47_c1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113441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17" descr="C:\Users\chosun\Desktop\progress report\17.02.15 progress report\siID3-MDC1,P-ID3\U2OSsiID3-2Gy-30min_P-ID3-crop3-Image Export-47_c1+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388320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18" descr="C:\Users\chosun\Desktop\progress report\17.02.15 progress report\siID3-MDC1,P-ID3\U2OSsiID3-2Gy-30min_P-ID3-crop3-Image Export-47_c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2507761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" name="Picture 19" descr="C:\Users\chosun\Desktop\progress report\17.02.15 progress report\siID3-MDC1,P-ID3\U2OSsiID3-2Gy-30min_P-ID3-crop4-Image Export-48_c1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7526" y="1134416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직사각형 25"/>
          <p:cNvSpPr/>
          <p:nvPr/>
        </p:nvSpPr>
        <p:spPr>
          <a:xfrm>
            <a:off x="2862805" y="1015616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303657098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237019" y="535422"/>
            <a:ext cx="152317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HeLa-siMDC1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21" descr="C:\Users\chosun\Desktop\progress report\17.02.28 progress report\17.02.28 U2OS P-ID3 early time\U2OSP-ID3-10Gy-40min-crop3-Image Export-37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9464" y="1242107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2" descr="C:\Users\chosun\Desktop\progress report\17.02.28 progress report\17.02.28 U2OS P-ID3 early time\U2OSP-ID3-10Gy-40min-crop3-Image Export-37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9464" y="3946613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23" descr="C:\Users\chosun\Desktop\progress report\17.02.28 progress report\17.02.28 U2OS P-ID3 early time\U2OSP-ID3-10Gy-40min-crop3-Image Export-37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9464" y="2594360"/>
            <a:ext cx="1329231" cy="132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5436096" y="535421"/>
            <a:ext cx="123783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dirty="0" smtClean="0">
                <a:latin typeface="Arial" panose="020B0604020202020204" pitchFamily="34" charset="0"/>
                <a:cs typeface="Arial" panose="020B0604020202020204" pitchFamily="34" charset="0"/>
              </a:rPr>
              <a:t>IR 180 </a:t>
            </a:r>
            <a:r>
              <a:rPr lang="en-US" altLang="ko-KR" sz="1662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lang="ko-KR" alt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41" descr="C:\Users\chosun\Desktop\progress report\17.06.22 U2OS siMDC1-P-ID3\U2OSsiMDC1-P-ID3-crop13-Image Export-02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7549" y="1242107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42" descr="C:\Users\chosun\Desktop\progress report\17.06.22 U2OS siMDC1-P-ID3\U2OSsiMDC1-P-ID3-crop13-Image Export-02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7549" y="3946614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43" descr="C:\Users\chosun\Desktop\progress report\17.06.22 U2OS siMDC1-P-ID3\U2OSsiMDC1-P-ID3-crop13-Image Export-02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7549" y="259436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44" descr="C:\Users\chosun\Desktop\progress report\17.06.22 U2OS siMDC1-P-ID3\U2OSsiMDC1-P-ID3-crop14-Image Export-03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5656" y="1242107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45" descr="C:\Users\chosun\Desktop\progress report\17.06.22 U2OS siMDC1-P-ID3\U2OSsiMDC1-P-ID3-crop14-Image Export-03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5657" y="3946614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46" descr="C:\Users\chosun\Desktop\progress report\17.06.22 U2OS siMDC1-P-ID3\U2OSsiMDC1-P-ID3-crop14-Image Export-03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5657" y="259436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47" descr="C:\Users\chosun\Desktop\progress report\17.06.22 U2OS siMDC1-P-ID3\U2OSsiMDC1-P-ID3-crop15-Image Export-04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0616" y="1242107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48" descr="C:\Users\chosun\Desktop\progress report\17.06.22 U2OS siMDC1-P-ID3\U2OSsiMDC1-P-ID3-crop15-Image Export-04_c1+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0617" y="3946614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49" descr="C:\Users\chosun\Desktop\progress report\17.06.22 U2OS siMDC1-P-ID3\U2OSsiMDC1-P-ID3-crop15-Image Export-04_c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0617" y="259436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53" descr="C:\Users\chosun\Desktop\progress report\17.06.22 U2OS siMDC1-P-ID3\U2OSsiMDC1-P-ID3-crop17-Image Export-06_c1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271" y="1214064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54" descr="C:\Users\chosun\Desktop\progress report\17.06.22 U2OS siMDC1-P-ID3\U2OSsiMDC1-P-ID3-crop17-Image Export-06_c1+2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810" y="3946614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" name="Picture 55" descr="C:\Users\chosun\Desktop\progress report\17.06.22 U2OS siMDC1-P-ID3\U2OSsiMDC1-P-ID3-crop17-Image Export-06_c2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271" y="259436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" name="Picture 20" descr="C:\Users\chosun\Desktop\progress report\17.06.22 U2OS siMDC1-P-ID3\U2OSsiMDC1-P-ID3-crop6-Image Export-19_c1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09441" y="1242107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7" name="Picture 21" descr="C:\Users\chosun\Desktop\progress report\17.06.22 U2OS siMDC1-P-ID3\U2OSsiMDC1-P-ID3-crop6-Image Export-19_c1+2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09441" y="3946614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22" descr="C:\Users\chosun\Desktop\progress report\17.06.22 U2OS siMDC1-P-ID3\U2OSsiMDC1-P-ID3-crop6-Image Export-19_c2.jp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09441" y="2594361"/>
            <a:ext cx="1329231" cy="1329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직사각형 22"/>
          <p:cNvSpPr/>
          <p:nvPr/>
        </p:nvSpPr>
        <p:spPr>
          <a:xfrm>
            <a:off x="3369934" y="1015616"/>
            <a:ext cx="1555722" cy="311144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62"/>
          </a:p>
        </p:txBody>
      </p:sp>
    </p:spTree>
    <p:extLst>
      <p:ext uri="{BB962C8B-B14F-4D97-AF65-F5344CB8AC3E}">
        <p14:creationId xmlns:p14="http://schemas.microsoft.com/office/powerpoint/2010/main" val="30416547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G:\13.06.25 U2OS siMDC1-PID3.mdb\U2OSsiCTL-P-ID3-3hr-3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G:\13.06.25 U2OS siMDC1-PID3.mdb\U2OSsiCTL-P-ID3-3hr-4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41493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G:\13.06.25 U2OS siMDC1-PID3.mdb\U2OSsiCTL-P-ID3-3hr-4_c1+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469199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G:\13.06.25 U2OS siMDC1-PID3.mdb\U2OSsiCTL-P-ID3-3hr-4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G:\13.06.25 U2OS siMDC1-PID3.mdb\U2OSsiCTL-P-ID3-3hr-1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41493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G:\13.06.25 U2OS siMDC1-PID3.mdb\U2OSsiCTL-P-ID3-3hr-1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469358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8" descr="G:\13.06.25 U2OS siMDC1-PID3.mdb\U2OSsiCTL-P-ID3-3hr-1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256128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5" name="Picture 9" descr="G:\13.06.25 U2OS siMDC1-PID3.mdb\U2OSsiCTL-P-ID3-3hr-2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6326" y="39870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6" name="Picture 10" descr="G:\13.06.25 U2OS siMDC1-PID3.mdb\U2OSsiCTL-P-ID3-3hr-2_c1+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469358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7" name="Picture 11" descr="G:\13.06.25 U2OS siMDC1-PID3.mdb\U2OSsiCTL-P-ID3-3hr-2_c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6326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8" name="Picture 12" descr="G:\13.06.25 U2OS siMDC1-PID3.mdb\U2OSsiCTL-P-ID3-3hr-3_c1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39870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9" name="Picture 13" descr="G:\13.06.25 U2OS siMDC1-PID3.mdb\U2OSsiCTL-P-ID3-3hr-3_c1+2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404734" y="194335"/>
            <a:ext cx="18966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60min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327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G:\13.06.25 U2OS siMDC1-PID3.mdb\U2OSsiCTL-P-ID3-6hr-3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5561" y="22919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G:\13.06.25 U2OS siMDC1-PID3.mdb\U2OSsiCTL-P-ID3-6hr-4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265669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8" name="Picture 8" descr="G:\13.06.25 U2OS siMDC1-PID3.mdb\U2OSsiCTL-P-ID3-6hr-1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6106" y="22919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1" name="Picture 11" descr="G:\13.06.25 U2OS siMDC1-PID3.mdb\U2OSsiCTL-P-ID3-6hr-2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7362" y="22919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6" name="Picture 26" descr="G:\13.06.25 U2OS siMDC1-PID3.mdb\U2OSsiCTL-P-ID3-6hr-3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9627" y="242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7" name="Picture 27" descr="G:\13.06.25 U2OS siMDC1-PID3.mdb\U2OSsiCTL-P-ID3-6hr-4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242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8" name="Picture 28" descr="G:\13.06.25 U2OS siMDC1-PID3.mdb\U2OSsiCTL-P-ID3-6hr-1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0146" y="242251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49" name="Picture 29" descr="G:\13.06.25 U2OS siMDC1-PID3.mdb\U2OSsiCTL-P-ID3-6hr-2_c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6263" y="242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50" name="Picture 30" descr="G:\13.06.25 U2OS siMDC1-PID3.mdb\U2OSsiCTL-P-ID3-6hr-4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458112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51" name="Picture 31" descr="G:\13.06.25 U2OS siMDC1-PID3.mdb\U2OSsiCTL-P-ID3-6hr-1_c1+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0146" y="459152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52" name="Picture 32" descr="G:\13.06.25 U2OS siMDC1-PID3.mdb\U2OSsiCTL-P-ID3-6hr-2_c1+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6263" y="457970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53" name="Picture 33" descr="G:\13.06.25 U2OS siMDC1-PID3.mdb\U2OSsiCTL-P-ID3-6hr-3_c1+2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5561" y="458112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404733" y="194335"/>
            <a:ext cx="18966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TL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 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3h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16128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G:\13.06.25 U2OS siMDC1-PID3.mdb\U2OSsiMDC1-P-ID3-0hr-2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4215" y="40466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G:\13.06.25 U2OS siMDC1-PID3.mdb\U2OSsiMDC1-P-ID3-0hr-2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4215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G:\13.06.25 U2OS siMDC1-PID3.mdb\U2OSsiMDC1-P-ID3-0hr-2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4215" y="254892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G:\13.06.25 U2OS siMDC1-PID3.mdb\U2OSsiMDC1-P-ID3-0hr-1_c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6296" y="40466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 descr="G:\13.06.25 U2OS siMDC1-PID3.mdb\U2OSsiMDC1-P-ID3-0hr-1_c1+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6296" y="4712431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1" name="Picture 7" descr="G:\13.06.25 U2OS siMDC1-PID3.mdb\U2OSsiMDC1-P-ID3-0hr-1_c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4455" y="254892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21991" y="194335"/>
            <a:ext cx="226215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-ID3 </a:t>
            </a:r>
          </a:p>
          <a:p>
            <a:pPr algn="ctr"/>
            <a:r>
              <a:rPr lang="en-US" altLang="ko-KR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Gy-0hr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5066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G:\13.06.25 U2OS siMDC1-PID3.mdb\U2OSsiMDC1-P-ID3-30min-3_c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8264" y="242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G:\13.06.25 U2OS siMDC1-PID3.mdb\U2OSsiMDC1-P-ID3-30min-4_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683" y="459453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G:\13.06.25 U2OS siMDC1-PID3.mdb\U2OSsiMDC1-P-ID3-30min-4_c1+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683" y="24036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3" name="Picture 5" descr="G:\13.06.25 U2OS siMDC1-PID3.mdb\U2OSsiMDC1-P-ID3-30min-4_c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683" y="2446080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4" name="Picture 6" descr="G:\13.06.25 U2OS siMDC1-PID3.mdb\U2OSsiMDC1-P-ID3-30min-1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7784" y="237473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5" name="Picture 7" descr="G:\13.06.25 U2OS siMDC1-PID3.mdb\U2OSsiMDC1-P-ID3-30min-1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4680" y="458112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6" name="Picture 8" descr="G:\13.06.25 U2OS siMDC1-PID3.mdb\U2OSsiMDC1-P-ID3-30min-1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7784" y="2458656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7" name="Picture 9" descr="G:\13.06.25 U2OS siMDC1-PID3.mdb\U2OSsiMDC1-P-ID3-30min-2_c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20757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8" name="Picture 10" descr="G:\13.06.25 U2OS siMDC1-PID3.mdb\U2OSsiMDC1-P-ID3-30min-2_c1+2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459453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9" name="Picture 11" descr="G:\13.06.25 U2OS siMDC1-PID3.mdb\U2OSsiMDC1-P-ID3-30min-2_c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242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80" name="Picture 12" descr="G:\13.06.25 U2OS siMDC1-PID3.mdb\U2OSsiMDC1-P-ID3-30min-3_c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8264" y="206813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81" name="Picture 13" descr="G:\13.06.25 U2OS siMDC1-PID3.mdb\U2OSsiMDC1-P-ID3-30min-3_c1+2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8264" y="461029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232411" y="194335"/>
            <a:ext cx="22413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20min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5066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G:\13.06.25 U2OS siMDC1-PID3.mdb\U2OSsiMDC1-P-ID3-1hr-3_c1+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G:\13.06.25 U2OS siMDC1-PID3.mdb\U2OSsiMDC1-P-ID3-1hr-3_c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257197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6" name="Picture 4" descr="G:\13.06.25 U2OS siMDC1-PID3.mdb\U2OSsiMDC1-P-ID3-1hr-4_c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42183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7" name="Picture 5" descr="G:\13.06.25 U2OS siMDC1-PID3.mdb\U2OSsiMDC1-P-ID3-1hr-4_c1+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8" name="Picture 6" descr="G:\13.06.25 U2OS siMDC1-PID3.mdb\U2OSsiMDC1-P-ID3-1hr-4_c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03623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9" name="Picture 7" descr="G:\13.06.25 U2OS siMDC1-PID3.mdb\U2OSsiMDC1-P-ID3-1hr-1_c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433613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0" name="Picture 8" descr="G:\13.06.25 U2OS siMDC1-PID3.mdb\U2OSsiMDC1-P-ID3-1hr-1_c1+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1" name="Picture 9" descr="G:\13.06.25 U2OS siMDC1-PID3.mdb\U2OSsiMDC1-P-ID3-1hr-1_c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8166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2" name="Picture 10" descr="G:\13.06.25 U2OS siMDC1-PID3.mdb\U2OSsiMDC1-P-ID3-1hr-2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4850" y="433613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3" name="Picture 11" descr="G:\13.06.25 U2OS siMDC1-PID3.mdb\U2OSsiMDC1-P-ID3-1hr-2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1800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4" name="Picture 12" descr="G:\13.06.25 U2OS siMDC1-PID3.mdb\U2OSsiMDC1-P-ID3-1hr-2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9465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5" name="Picture 13" descr="G:\13.06.25 U2OS siMDC1-PID3.mdb\U2OSsiMDC1-P-ID3-1hr-3_c1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440888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232411" y="194335"/>
            <a:ext cx="22413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40 min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5066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G:\13.06.25 U2OS siMDC1-PID3.mdb\U2OSsiMDC1-P-ID3-3hr-2_c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39494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9" name="Picture 3" descr="G:\13.06.25 U2OS siMDC1-PID3.mdb\U2OSsiMDC1-P-ID3-3hr-2_c1+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4723962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0" name="Picture 4" descr="G:\13.06.25 U2OS siMDC1-PID3.mdb\U2OSsiMDC1-P-ID3-3hr-2_c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1" name="Picture 5" descr="G:\13.06.25 U2OS siMDC1-PID3.mdb\U2OSsiMDC1-P-ID3-3hr-3_c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39494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2" name="Picture 6" descr="G:\13.06.25 U2OS siMDC1-PID3.mdb\U2OSsiMDC1-P-ID3-3hr-3_c1+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5841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3" name="Picture 7" descr="G:\13.06.25 U2OS siMDC1-PID3.mdb\U2OSsiMDC1-P-ID3-3hr-3_c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4" name="Picture 8" descr="G:\13.06.25 U2OS siMDC1-PID3.mdb\U2OSsiMDC1-P-ID3-3hr-4_c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7369" y="394945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5" name="Picture 9" descr="G:\13.06.25 U2OS siMDC1-PID3.mdb\U2OSsiMDC1-P-ID3-3hr-4_c1+2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6" name="Picture 10" descr="G:\13.06.25 U2OS siMDC1-PID3.mdb\U2OSsiMDC1-P-ID3-3hr-4_c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0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7" name="Picture 11" descr="G:\13.06.25 U2OS siMDC1-PID3.mdb\U2OSsiMDC1-P-ID3-3hr-1_c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391861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8" name="Picture 12" descr="G:\13.06.25 U2OS siMDC1-PID3.mdb\U2OSsiMDC1-P-ID3-3hr-1_c1+2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472514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9" name="Picture 13" descr="G:\13.06.25 U2OS siMDC1-PID3.mdb\U2OSsiMDC1-P-ID3-3hr-1_c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0272" y="2564904"/>
            <a:ext cx="1980000" cy="19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232411" y="194335"/>
            <a:ext cx="22413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 </a:t>
            </a:r>
            <a:r>
              <a:rPr lang="en-US" altLang="ko-KR" sz="24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DC1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ID3</a:t>
            </a:r>
          </a:p>
          <a:p>
            <a:pPr algn="ctr"/>
            <a:r>
              <a:rPr lang="en-US" altLang="ko-KR" sz="2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y-1hr</a:t>
            </a:r>
            <a:endParaRPr lang="ko-KR" altLang="en-US" sz="2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506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0</TotalTime>
  <Words>151</Words>
  <Application>Microsoft Office PowerPoint</Application>
  <PresentationFormat>화면 슬라이드 쇼(4:3)</PresentationFormat>
  <Paragraphs>88</Paragraphs>
  <Slides>3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1</vt:i4>
      </vt:variant>
    </vt:vector>
  </HeadingPairs>
  <TitlesOfParts>
    <vt:vector size="34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hahamj</dc:creator>
  <cp:lastModifiedBy>chosun</cp:lastModifiedBy>
  <cp:revision>16</cp:revision>
  <dcterms:created xsi:type="dcterms:W3CDTF">2013-06-30T06:13:09Z</dcterms:created>
  <dcterms:modified xsi:type="dcterms:W3CDTF">2018-05-02T13:05:03Z</dcterms:modified>
</cp:coreProperties>
</file>